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0696E0-7F3F-4CB5-854A-1FF2D30423D4}" v="4" dt="2025-09-05T06:38:22.7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15" autoAdjust="0"/>
    <p:restoredTop sz="94660"/>
  </p:normalViewPr>
  <p:slideViewPr>
    <p:cSldViewPr>
      <p:cViewPr varScale="1">
        <p:scale>
          <a:sx n="112" d="100"/>
          <a:sy n="112" d="100"/>
        </p:scale>
        <p:origin x="1860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ba Macià Puig" userId="9964446f-4a35-43ae-bfc8-09df1c431cba" providerId="ADAL" clId="{F2397C98-FB7B-4CCB-85B6-655D1C0E4E89}"/>
    <pc:docChg chg="modSld">
      <pc:chgData name="Alba Macià Puig" userId="9964446f-4a35-43ae-bfc8-09df1c431cba" providerId="ADAL" clId="{F2397C98-FB7B-4CCB-85B6-655D1C0E4E89}" dt="2025-07-18T08:52:33.168" v="3" actId="164"/>
      <pc:docMkLst>
        <pc:docMk/>
      </pc:docMkLst>
      <pc:sldChg chg="addSp delSp modSp">
        <pc:chgData name="Alba Macià Puig" userId="9964446f-4a35-43ae-bfc8-09df1c431cba" providerId="ADAL" clId="{F2397C98-FB7B-4CCB-85B6-655D1C0E4E89}" dt="2025-07-18T08:52:33.168" v="3" actId="164"/>
        <pc:sldMkLst>
          <pc:docMk/>
          <pc:sldMk cId="1969973305" sldId="258"/>
        </pc:sldMkLst>
      </pc:sldChg>
    </pc:docChg>
  </pc:docChgLst>
  <pc:docChgLst>
    <pc:chgData name="Alba Macià Puig" userId="9964446f-4a35-43ae-bfc8-09df1c431cba" providerId="ADAL" clId="{2C0696E0-7F3F-4CB5-854A-1FF2D30423D4}"/>
    <pc:docChg chg="modSld">
      <pc:chgData name="Alba Macià Puig" userId="9964446f-4a35-43ae-bfc8-09df1c431cba" providerId="ADAL" clId="{2C0696E0-7F3F-4CB5-854A-1FF2D30423D4}" dt="2025-09-05T06:38:24.778" v="7" actId="6549"/>
      <pc:docMkLst>
        <pc:docMk/>
      </pc:docMkLst>
      <pc:sldChg chg="addSp delSp modSp mod">
        <pc:chgData name="Alba Macià Puig" userId="9964446f-4a35-43ae-bfc8-09df1c431cba" providerId="ADAL" clId="{2C0696E0-7F3F-4CB5-854A-1FF2D30423D4}" dt="2025-09-05T06:38:24.778" v="7" actId="6549"/>
        <pc:sldMkLst>
          <pc:docMk/>
          <pc:sldMk cId="1969973305" sldId="258"/>
        </pc:sldMkLst>
        <pc:spChg chg="add del mod">
          <ac:chgData name="Alba Macià Puig" userId="9964446f-4a35-43ae-bfc8-09df1c431cba" providerId="ADAL" clId="{2C0696E0-7F3F-4CB5-854A-1FF2D30423D4}" dt="2025-09-05T06:38:21.404" v="4" actId="478"/>
          <ac:spMkLst>
            <pc:docMk/>
            <pc:sldMk cId="1969973305" sldId="258"/>
            <ac:spMk id="2" creationId="{AC9A886F-A1ED-9213-0DEA-A4A28757DF1D}"/>
          </ac:spMkLst>
        </pc:spChg>
        <pc:spChg chg="add mod">
          <ac:chgData name="Alba Macià Puig" userId="9964446f-4a35-43ae-bfc8-09df1c431cba" providerId="ADAL" clId="{2C0696E0-7F3F-4CB5-854A-1FF2D30423D4}" dt="2025-09-05T06:38:24.778" v="7" actId="6549"/>
          <ac:spMkLst>
            <pc:docMk/>
            <pc:sldMk cId="1969973305" sldId="258"/>
            <ac:spMk id="11" creationId="{75C973A3-093C-ABA7-7CF4-45CB865433C3}"/>
          </ac:spMkLst>
        </pc:spChg>
      </pc:sldChg>
    </pc:docChg>
  </pc:docChgLst>
  <pc:docChgLst>
    <pc:chgData name="Alba Macià Puig" userId="9964446f-4a35-43ae-bfc8-09df1c431cba" providerId="ADAL" clId="{A2EDE032-8570-4837-95BD-EB4BCF950604}"/>
    <pc:docChg chg="undo custSel modSld">
      <pc:chgData name="Alba Macià Puig" userId="9964446f-4a35-43ae-bfc8-09df1c431cba" providerId="ADAL" clId="{A2EDE032-8570-4837-95BD-EB4BCF950604}" dt="2025-08-28T11:19:09.364" v="33" actId="255"/>
      <pc:docMkLst>
        <pc:docMk/>
      </pc:docMkLst>
      <pc:sldChg chg="addSp delSp modSp mod">
        <pc:chgData name="Alba Macià Puig" userId="9964446f-4a35-43ae-bfc8-09df1c431cba" providerId="ADAL" clId="{A2EDE032-8570-4837-95BD-EB4BCF950604}" dt="2025-08-28T11:19:09.364" v="33" actId="255"/>
        <pc:sldMkLst>
          <pc:docMk/>
          <pc:sldMk cId="1969973305" sldId="258"/>
        </pc:sldMkLst>
        <pc:spChg chg="mod">
          <ac:chgData name="Alba Macià Puig" userId="9964446f-4a35-43ae-bfc8-09df1c431cba" providerId="ADAL" clId="{A2EDE032-8570-4837-95BD-EB4BCF950604}" dt="2025-08-28T11:19:09.364" v="33" actId="255"/>
          <ac:spMkLst>
            <pc:docMk/>
            <pc:sldMk cId="1969973305" sldId="258"/>
            <ac:spMk id="22" creationId="{5A085B87-88C2-FE3B-01F7-6FC7EF4DC835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3" creationId="{FB3B42D6-44DE-6831-D5B6-C5807540E807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25" creationId="{18EE3F26-B098-FE1C-0840-5A8EAFA43348}"/>
          </ac:spMkLst>
        </pc:spChg>
        <pc:spChg chg="mod">
          <ac:chgData name="Alba Macià Puig" userId="9964446f-4a35-43ae-bfc8-09df1c431cba" providerId="ADAL" clId="{A2EDE032-8570-4837-95BD-EB4BCF950604}" dt="2025-08-28T11:19:07.003" v="30" actId="255"/>
          <ac:spMkLst>
            <pc:docMk/>
            <pc:sldMk cId="1969973305" sldId="258"/>
            <ac:spMk id="26" creationId="{0B039DFD-D2EC-89AC-C0B6-35C0DE6AF5C7}"/>
          </ac:spMkLst>
        </pc:spChg>
        <pc:spChg chg="mod">
          <ac:chgData name="Alba Macià Puig" userId="9964446f-4a35-43ae-bfc8-09df1c431cba" providerId="ADAL" clId="{A2EDE032-8570-4837-95BD-EB4BCF950604}" dt="2025-08-28T11:19:06.473" v="29" actId="255"/>
          <ac:spMkLst>
            <pc:docMk/>
            <pc:sldMk cId="1969973305" sldId="258"/>
            <ac:spMk id="27" creationId="{45A1A68E-CB21-EA14-2D83-8C7AEB04C3EF}"/>
          </ac:spMkLst>
        </pc:spChg>
        <pc:spChg chg="mod topLvl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186" creationId="{1F02D0DC-E05B-AD11-1130-81AAF3C64F01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187" creationId="{626C0965-3FE0-8F22-42B6-9E8C2C8945FB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56" creationId="{267AEECE-6E85-BEFC-5220-6085756DCD57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57" creationId="{1DBC467C-F35D-3CB1-7EA1-EF0C6D9ABC96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66" creationId="{C9F60F49-0504-07E2-A5E7-C15C8F72DEBB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82" creationId="{F7B177C2-5668-B309-512A-BE9FB6E08D81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92" creationId="{48FC953B-66AA-1D75-CFDA-BFF109F748D3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11" creationId="{9C384862-188E-B47C-8641-279B4200F074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12" creationId="{6CEB989A-DC5F-C0C5-66B3-6ED8561910BD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15" creationId="{59809619-8EF1-412D-FE0A-B0BCD6CA58A0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22" creationId="{22F698BF-13F0-880A-8F27-476FCDA969EE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25" creationId="{701E34BE-E5FD-8C40-0368-9DF84326D9D4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26" creationId="{FBEDAB8E-253D-6D15-D8ED-68BDED3FEDC8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29" creationId="{B296377D-7A85-988A-A34D-5449EB8D5D49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347" creationId="{C740C51E-A29D-06BD-5E27-6F5964AB1996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48" creationId="{82D316C2-4F7F-BB81-A37E-46F6F22DE909}"/>
          </ac:spMkLst>
        </pc:spChg>
        <pc:spChg chg="mod">
          <ac:chgData name="Alba Macià Puig" userId="9964446f-4a35-43ae-bfc8-09df1c431cba" providerId="ADAL" clId="{A2EDE032-8570-4837-95BD-EB4BCF950604}" dt="2025-08-28T11:18:06.479" v="20" actId="1035"/>
          <ac:spMkLst>
            <pc:docMk/>
            <pc:sldMk cId="1969973305" sldId="258"/>
            <ac:spMk id="351" creationId="{0308BD35-C9AD-E549-EDCC-C67B4DB15083}"/>
          </ac:spMkLst>
        </pc:spChg>
        <pc:spChg chg="mod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352" creationId="{0CB20B9C-627A-2C99-26DC-DFEA5EF5CE6D}"/>
          </ac:spMkLst>
        </pc:spChg>
        <pc:spChg chg="mod topLvl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372" creationId="{78B57B68-9230-9579-1860-9436E0BE0EE0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186" creationId="{23D6D2BF-0525-6D7A-BEA3-CF0870AF49E1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00" creationId="{B87F89D0-FC6F-388D-B860-3A06322D31CF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02" creationId="{3174BEE3-9CE9-B1A3-F2C8-AD96C29CAA84}"/>
          </ac:spMkLst>
        </pc:spChg>
        <pc:spChg chg="mod topLvl">
          <ac:chgData name="Alba Macià Puig" userId="9964446f-4a35-43ae-bfc8-09df1c431cba" providerId="ADAL" clId="{A2EDE032-8570-4837-95BD-EB4BCF950604}" dt="2025-08-28T11:18:32.066" v="23" actId="255"/>
          <ac:spMkLst>
            <pc:docMk/>
            <pc:sldMk cId="1969973305" sldId="258"/>
            <ac:spMk id="2208" creationId="{C8F85A50-4D2A-7B3C-F4B7-1C1216695CA9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10" creationId="{CA5E7E11-2DE3-B2E1-5DE8-49E625F37F66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11" creationId="{BA390062-132D-09DB-7631-A2940716820C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12" creationId="{94FBC5C3-95B2-5662-ACAD-043E3469C0DF}"/>
          </ac:spMkLst>
        </pc:spChg>
        <pc:spChg chg="mod">
          <ac:chgData name="Alba Macià Puig" userId="9964446f-4a35-43ae-bfc8-09df1c431cba" providerId="ADAL" clId="{A2EDE032-8570-4837-95BD-EB4BCF950604}" dt="2025-08-28T11:18:12.665" v="21" actId="164"/>
          <ac:spMkLst>
            <pc:docMk/>
            <pc:sldMk cId="1969973305" sldId="258"/>
            <ac:spMk id="2214" creationId="{BC684343-C7BD-0598-6FA1-4F01C961D49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3712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625709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104765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19441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756454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46093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635325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381933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25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934692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470939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6AF8AE-4B70-40DB-8995-7A85B0FEAA90}" type="datetimeFigureOut">
              <a:rPr lang="ca-ES" smtClean="0"/>
              <a:t>28/9/202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F82F6-095F-4050-A5A8-2E12790E1FA6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508167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4ED445-B38E-0A89-84ED-7A16DA736CB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Agrupa 8">
            <a:extLst>
              <a:ext uri="{FF2B5EF4-FFF2-40B4-BE49-F238E27FC236}">
                <a16:creationId xmlns:a16="http://schemas.microsoft.com/office/drawing/2014/main" id="{FCC79CF3-092E-B308-89AB-0815673F5A00}"/>
              </a:ext>
            </a:extLst>
          </p:cNvPr>
          <p:cNvGrpSpPr/>
          <p:nvPr/>
        </p:nvGrpSpPr>
        <p:grpSpPr>
          <a:xfrm>
            <a:off x="746606" y="548680"/>
            <a:ext cx="7857842" cy="5921909"/>
            <a:chOff x="747297" y="548680"/>
            <a:chExt cx="7252797" cy="5443471"/>
          </a:xfrm>
        </p:grpSpPr>
        <p:sp>
          <p:nvSpPr>
            <p:cNvPr id="158" name="Rectangle 224">
              <a:extLst>
                <a:ext uri="{FF2B5EF4-FFF2-40B4-BE49-F238E27FC236}">
                  <a16:creationId xmlns:a16="http://schemas.microsoft.com/office/drawing/2014/main" id="{CDF0FF32-81CB-566F-EF24-C76B3E710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714" y="2491696"/>
              <a:ext cx="2205038" cy="7938"/>
            </a:xfrm>
            <a:prstGeom prst="rect">
              <a:avLst/>
            </a:prstGeom>
            <a:solidFill>
              <a:srgbClr val="D9D9D9"/>
            </a:solidFill>
            <a:ln w="1588" cap="flat">
              <a:solidFill>
                <a:srgbClr val="D9D9D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186" name="Freeform 228">
              <a:extLst>
                <a:ext uri="{FF2B5EF4-FFF2-40B4-BE49-F238E27FC236}">
                  <a16:creationId xmlns:a16="http://schemas.microsoft.com/office/drawing/2014/main" id="{1F02D0DC-E05B-AD11-1130-81AAF3C64F0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812776" y="2313896"/>
              <a:ext cx="55563" cy="92075"/>
            </a:xfrm>
            <a:custGeom>
              <a:avLst/>
              <a:gdLst>
                <a:gd name="T0" fmla="*/ 16 w 35"/>
                <a:gd name="T1" fmla="*/ 58 h 58"/>
                <a:gd name="T2" fmla="*/ 16 w 35"/>
                <a:gd name="T3" fmla="*/ 2 h 58"/>
                <a:gd name="T4" fmla="*/ 20 w 35"/>
                <a:gd name="T5" fmla="*/ 2 h 58"/>
                <a:gd name="T6" fmla="*/ 20 w 35"/>
                <a:gd name="T7" fmla="*/ 58 h 58"/>
                <a:gd name="T8" fmla="*/ 16 w 35"/>
                <a:gd name="T9" fmla="*/ 58 h 58"/>
                <a:gd name="T10" fmla="*/ 0 w 35"/>
                <a:gd name="T11" fmla="*/ 0 h 58"/>
                <a:gd name="T12" fmla="*/ 35 w 35"/>
                <a:gd name="T13" fmla="*/ 0 h 58"/>
                <a:gd name="T14" fmla="*/ 35 w 35"/>
                <a:gd name="T15" fmla="*/ 4 h 58"/>
                <a:gd name="T16" fmla="*/ 0 w 35"/>
                <a:gd name="T17" fmla="*/ 4 h 58"/>
                <a:gd name="T18" fmla="*/ 0 w 35"/>
                <a:gd name="T19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58">
                  <a:moveTo>
                    <a:pt x="16" y="58"/>
                  </a:moveTo>
                  <a:lnTo>
                    <a:pt x="16" y="2"/>
                  </a:lnTo>
                  <a:lnTo>
                    <a:pt x="20" y="2"/>
                  </a:lnTo>
                  <a:lnTo>
                    <a:pt x="20" y="58"/>
                  </a:lnTo>
                  <a:lnTo>
                    <a:pt x="16" y="5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187" name="Freeform 229">
              <a:extLst>
                <a:ext uri="{FF2B5EF4-FFF2-40B4-BE49-F238E27FC236}">
                  <a16:creationId xmlns:a16="http://schemas.microsoft.com/office/drawing/2014/main" id="{626C0965-3FE0-8F22-42B6-9E8C2C8945F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252514" y="1618571"/>
              <a:ext cx="57150" cy="349250"/>
            </a:xfrm>
            <a:custGeom>
              <a:avLst/>
              <a:gdLst>
                <a:gd name="T0" fmla="*/ 16 w 36"/>
                <a:gd name="T1" fmla="*/ 220 h 220"/>
                <a:gd name="T2" fmla="*/ 16 w 36"/>
                <a:gd name="T3" fmla="*/ 1 h 220"/>
                <a:gd name="T4" fmla="*/ 20 w 36"/>
                <a:gd name="T5" fmla="*/ 1 h 220"/>
                <a:gd name="T6" fmla="*/ 20 w 36"/>
                <a:gd name="T7" fmla="*/ 220 h 220"/>
                <a:gd name="T8" fmla="*/ 16 w 36"/>
                <a:gd name="T9" fmla="*/ 220 h 220"/>
                <a:gd name="T10" fmla="*/ 0 w 36"/>
                <a:gd name="T11" fmla="*/ 0 h 220"/>
                <a:gd name="T12" fmla="*/ 36 w 36"/>
                <a:gd name="T13" fmla="*/ 0 h 220"/>
                <a:gd name="T14" fmla="*/ 36 w 36"/>
                <a:gd name="T15" fmla="*/ 3 h 220"/>
                <a:gd name="T16" fmla="*/ 0 w 36"/>
                <a:gd name="T17" fmla="*/ 3 h 220"/>
                <a:gd name="T18" fmla="*/ 0 w 36"/>
                <a:gd name="T19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220">
                  <a:moveTo>
                    <a:pt x="16" y="220"/>
                  </a:moveTo>
                  <a:lnTo>
                    <a:pt x="16" y="1"/>
                  </a:lnTo>
                  <a:lnTo>
                    <a:pt x="20" y="1"/>
                  </a:lnTo>
                  <a:lnTo>
                    <a:pt x="20" y="220"/>
                  </a:lnTo>
                  <a:lnTo>
                    <a:pt x="16" y="220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77" name="Freeform 235">
              <a:extLst>
                <a:ext uri="{FF2B5EF4-FFF2-40B4-BE49-F238E27FC236}">
                  <a16:creationId xmlns:a16="http://schemas.microsoft.com/office/drawing/2014/main" id="{6195C06C-12CB-1A57-7D43-D9E16E1BDD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4676" y="1953533"/>
              <a:ext cx="1792288" cy="555625"/>
            </a:xfrm>
            <a:custGeom>
              <a:avLst/>
              <a:gdLst>
                <a:gd name="T0" fmla="*/ 144 w 18815"/>
                <a:gd name="T1" fmla="*/ 5550 h 5838"/>
                <a:gd name="T2" fmla="*/ 4768 w 18815"/>
                <a:gd name="T3" fmla="*/ 5550 h 5838"/>
                <a:gd name="T4" fmla="*/ 9392 w 18815"/>
                <a:gd name="T5" fmla="*/ 5550 h 5838"/>
                <a:gd name="T6" fmla="*/ 9364 w 18815"/>
                <a:gd name="T7" fmla="*/ 5553 h 5838"/>
                <a:gd name="T8" fmla="*/ 14004 w 18815"/>
                <a:gd name="T9" fmla="*/ 4609 h 5838"/>
                <a:gd name="T10" fmla="*/ 13931 w 18815"/>
                <a:gd name="T11" fmla="*/ 4648 h 5838"/>
                <a:gd name="T12" fmla="*/ 18555 w 18815"/>
                <a:gd name="T13" fmla="*/ 56 h 5838"/>
                <a:gd name="T14" fmla="*/ 18759 w 18815"/>
                <a:gd name="T15" fmla="*/ 57 h 5838"/>
                <a:gd name="T16" fmla="*/ 18758 w 18815"/>
                <a:gd name="T17" fmla="*/ 261 h 5838"/>
                <a:gd name="T18" fmla="*/ 14134 w 18815"/>
                <a:gd name="T19" fmla="*/ 4853 h 5838"/>
                <a:gd name="T20" fmla="*/ 14061 w 18815"/>
                <a:gd name="T21" fmla="*/ 4892 h 5838"/>
                <a:gd name="T22" fmla="*/ 9421 w 18815"/>
                <a:gd name="T23" fmla="*/ 5836 h 5838"/>
                <a:gd name="T24" fmla="*/ 9392 w 18815"/>
                <a:gd name="T25" fmla="*/ 5838 h 5838"/>
                <a:gd name="T26" fmla="*/ 4768 w 18815"/>
                <a:gd name="T27" fmla="*/ 5838 h 5838"/>
                <a:gd name="T28" fmla="*/ 144 w 18815"/>
                <a:gd name="T29" fmla="*/ 5838 h 5838"/>
                <a:gd name="T30" fmla="*/ 0 w 18815"/>
                <a:gd name="T31" fmla="*/ 5694 h 5838"/>
                <a:gd name="T32" fmla="*/ 144 w 18815"/>
                <a:gd name="T33" fmla="*/ 5550 h 58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8815" h="5838">
                  <a:moveTo>
                    <a:pt x="144" y="5550"/>
                  </a:moveTo>
                  <a:lnTo>
                    <a:pt x="4768" y="5550"/>
                  </a:lnTo>
                  <a:lnTo>
                    <a:pt x="9392" y="5550"/>
                  </a:lnTo>
                  <a:lnTo>
                    <a:pt x="9364" y="5553"/>
                  </a:lnTo>
                  <a:lnTo>
                    <a:pt x="14004" y="4609"/>
                  </a:lnTo>
                  <a:lnTo>
                    <a:pt x="13931" y="4648"/>
                  </a:lnTo>
                  <a:lnTo>
                    <a:pt x="18555" y="56"/>
                  </a:lnTo>
                  <a:cubicBezTo>
                    <a:pt x="18611" y="0"/>
                    <a:pt x="18703" y="1"/>
                    <a:pt x="18759" y="57"/>
                  </a:cubicBezTo>
                  <a:cubicBezTo>
                    <a:pt x="18815" y="113"/>
                    <a:pt x="18814" y="205"/>
                    <a:pt x="18758" y="261"/>
                  </a:cubicBezTo>
                  <a:lnTo>
                    <a:pt x="14134" y="4853"/>
                  </a:lnTo>
                  <a:cubicBezTo>
                    <a:pt x="14114" y="4872"/>
                    <a:pt x="14089" y="4886"/>
                    <a:pt x="14061" y="4892"/>
                  </a:cubicBezTo>
                  <a:lnTo>
                    <a:pt x="9421" y="5836"/>
                  </a:lnTo>
                  <a:cubicBezTo>
                    <a:pt x="9412" y="5837"/>
                    <a:pt x="9402" y="5838"/>
                    <a:pt x="9392" y="5838"/>
                  </a:cubicBezTo>
                  <a:lnTo>
                    <a:pt x="4768" y="5838"/>
                  </a:lnTo>
                  <a:lnTo>
                    <a:pt x="144" y="5838"/>
                  </a:lnTo>
                  <a:cubicBezTo>
                    <a:pt x="65" y="5838"/>
                    <a:pt x="0" y="5774"/>
                    <a:pt x="0" y="5694"/>
                  </a:cubicBezTo>
                  <a:cubicBezTo>
                    <a:pt x="0" y="5615"/>
                    <a:pt x="65" y="5550"/>
                    <a:pt x="144" y="5550"/>
                  </a:cubicBezTo>
                  <a:close/>
                </a:path>
              </a:pathLst>
            </a:custGeom>
            <a:solidFill>
              <a:srgbClr val="5B9BD5"/>
            </a:solidFill>
            <a:ln w="1588" cap="flat">
              <a:solidFill>
                <a:srgbClr val="5B9BD5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84" name="Oval 242">
              <a:extLst>
                <a:ext uri="{FF2B5EF4-FFF2-40B4-BE49-F238E27FC236}">
                  <a16:creationId xmlns:a16="http://schemas.microsoft.com/office/drawing/2014/main" id="{FDDFE17C-0F1F-2133-31C5-C33892CD52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014" y="2374221"/>
              <a:ext cx="63500" cy="63500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85" name="Oval 243">
              <a:extLst>
                <a:ext uri="{FF2B5EF4-FFF2-40B4-BE49-F238E27FC236}">
                  <a16:creationId xmlns:a16="http://schemas.microsoft.com/office/drawing/2014/main" id="{487F494B-DA68-2829-B74A-C1EFA742F8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8014" y="2374221"/>
              <a:ext cx="63500" cy="63500"/>
            </a:xfrm>
            <a:prstGeom prst="ellipse">
              <a:avLst/>
            </a:prstGeom>
            <a:noFill/>
            <a:ln w="9525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86" name="Oval 244">
              <a:extLst>
                <a:ext uri="{FF2B5EF4-FFF2-40B4-BE49-F238E27FC236}">
                  <a16:creationId xmlns:a16="http://schemas.microsoft.com/office/drawing/2014/main" id="{23D6D2BF-0525-6D7A-BEA3-CF0870AF49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7751" y="1934483"/>
              <a:ext cx="65088" cy="65088"/>
            </a:xfrm>
            <a:prstGeom prst="ellipse">
              <a:avLst/>
            </a:prstGeom>
            <a:solidFill>
              <a:srgbClr val="5B9BD5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87" name="Oval 245">
              <a:extLst>
                <a:ext uri="{FF2B5EF4-FFF2-40B4-BE49-F238E27FC236}">
                  <a16:creationId xmlns:a16="http://schemas.microsoft.com/office/drawing/2014/main" id="{084D562D-1159-B6DA-A89B-00616290A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7751" y="1934483"/>
              <a:ext cx="65088" cy="65088"/>
            </a:xfrm>
            <a:prstGeom prst="ellipse">
              <a:avLst/>
            </a:prstGeom>
            <a:noFill/>
            <a:ln w="9525" cap="flat">
              <a:solidFill>
                <a:srgbClr val="5B9BD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ca-ES" sz="1200">
                <a:latin typeface="Palatino Linotype" panose="02040502050505030304" pitchFamily="18" charset="0"/>
              </a:endParaRPr>
            </a:p>
          </p:txBody>
        </p:sp>
        <p:sp>
          <p:nvSpPr>
            <p:cNvPr id="2199" name="Rectangle 257">
              <a:extLst>
                <a:ext uri="{FF2B5EF4-FFF2-40B4-BE49-F238E27FC236}">
                  <a16:creationId xmlns:a16="http://schemas.microsoft.com/office/drawing/2014/main" id="{30FD5BC3-0408-D73A-37AF-2175E4AE1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4789" y="2418671"/>
              <a:ext cx="7101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2200" name="Rectangle 258">
              <a:extLst>
                <a:ext uri="{FF2B5EF4-FFF2-40B4-BE49-F238E27FC236}">
                  <a16:creationId xmlns:a16="http://schemas.microsoft.com/office/drawing/2014/main" id="{B87F89D0-FC6F-388D-B860-3A06322D31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639" y="2201183"/>
              <a:ext cx="14203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0</a:t>
              </a:r>
            </a:p>
          </p:txBody>
        </p:sp>
        <p:sp>
          <p:nvSpPr>
            <p:cNvPr id="2201" name="Rectangle 259">
              <a:extLst>
                <a:ext uri="{FF2B5EF4-FFF2-40B4-BE49-F238E27FC236}">
                  <a16:creationId xmlns:a16="http://schemas.microsoft.com/office/drawing/2014/main" id="{541A0010-3797-C084-8834-0EA7DE758F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639" y="1983696"/>
              <a:ext cx="14203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20</a:t>
              </a:r>
            </a:p>
          </p:txBody>
        </p:sp>
        <p:sp>
          <p:nvSpPr>
            <p:cNvPr id="2202" name="Rectangle 260">
              <a:extLst>
                <a:ext uri="{FF2B5EF4-FFF2-40B4-BE49-F238E27FC236}">
                  <a16:creationId xmlns:a16="http://schemas.microsoft.com/office/drawing/2014/main" id="{3174BEE3-9CE9-B1A3-F2C8-AD96C29CAA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639" y="1766208"/>
              <a:ext cx="14203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30</a:t>
              </a:r>
            </a:p>
          </p:txBody>
        </p:sp>
        <p:sp>
          <p:nvSpPr>
            <p:cNvPr id="2203" name="Rectangle 261">
              <a:extLst>
                <a:ext uri="{FF2B5EF4-FFF2-40B4-BE49-F238E27FC236}">
                  <a16:creationId xmlns:a16="http://schemas.microsoft.com/office/drawing/2014/main" id="{69E190FF-37F3-3CEC-A729-4486DB7B05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639" y="1547133"/>
              <a:ext cx="14203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40</a:t>
              </a:r>
            </a:p>
          </p:txBody>
        </p:sp>
        <p:sp>
          <p:nvSpPr>
            <p:cNvPr id="2204" name="Rectangle 262">
              <a:extLst>
                <a:ext uri="{FF2B5EF4-FFF2-40B4-BE49-F238E27FC236}">
                  <a16:creationId xmlns:a16="http://schemas.microsoft.com/office/drawing/2014/main" id="{D838E041-7A8E-463B-2379-8B3FEE03E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639" y="1329646"/>
              <a:ext cx="14203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50</a:t>
              </a:r>
            </a:p>
          </p:txBody>
        </p:sp>
        <p:sp>
          <p:nvSpPr>
            <p:cNvPr id="2208" name="Rectangle 263">
              <a:extLst>
                <a:ext uri="{FF2B5EF4-FFF2-40B4-BE49-F238E27FC236}">
                  <a16:creationId xmlns:a16="http://schemas.microsoft.com/office/drawing/2014/main" id="{C8F85A50-4D2A-7B3C-F4B7-1C1216695C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4221" y="2567896"/>
              <a:ext cx="18938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0 h</a:t>
              </a:r>
            </a:p>
          </p:txBody>
        </p:sp>
        <p:sp>
          <p:nvSpPr>
            <p:cNvPr id="2209" name="Rectangle 264">
              <a:extLst>
                <a:ext uri="{FF2B5EF4-FFF2-40B4-BE49-F238E27FC236}">
                  <a16:creationId xmlns:a16="http://schemas.microsoft.com/office/drawing/2014/main" id="{3B950920-AE3D-C054-4932-68B06E537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264" y="2567896"/>
              <a:ext cx="18938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1 h</a:t>
              </a:r>
            </a:p>
          </p:txBody>
        </p:sp>
        <p:sp>
          <p:nvSpPr>
            <p:cNvPr id="2210" name="Rectangle 265">
              <a:extLst>
                <a:ext uri="{FF2B5EF4-FFF2-40B4-BE49-F238E27FC236}">
                  <a16:creationId xmlns:a16="http://schemas.microsoft.com/office/drawing/2014/main" id="{CA5E7E11-2DE3-B2E1-5DE8-49E625F37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589" y="2567896"/>
              <a:ext cx="18938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2 h</a:t>
              </a:r>
            </a:p>
          </p:txBody>
        </p:sp>
        <p:sp>
          <p:nvSpPr>
            <p:cNvPr id="2211" name="Rectangle 266">
              <a:extLst>
                <a:ext uri="{FF2B5EF4-FFF2-40B4-BE49-F238E27FC236}">
                  <a16:creationId xmlns:a16="http://schemas.microsoft.com/office/drawing/2014/main" id="{BA390062-132D-09DB-7631-A294071682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626" y="2567896"/>
              <a:ext cx="22489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4 h</a:t>
              </a:r>
            </a:p>
          </p:txBody>
        </p:sp>
        <p:sp>
          <p:nvSpPr>
            <p:cNvPr id="2212" name="Rectangle 267">
              <a:extLst>
                <a:ext uri="{FF2B5EF4-FFF2-40B4-BE49-F238E27FC236}">
                  <a16:creationId xmlns:a16="http://schemas.microsoft.com/office/drawing/2014/main" id="{94FBC5C3-95B2-5662-ACAD-043E3469C0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9651" y="2567896"/>
              <a:ext cx="18938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6 h</a:t>
              </a:r>
            </a:p>
          </p:txBody>
        </p:sp>
        <p:sp>
          <p:nvSpPr>
            <p:cNvPr id="2214" name="Rectangle 269">
              <a:extLst>
                <a:ext uri="{FF2B5EF4-FFF2-40B4-BE49-F238E27FC236}">
                  <a16:creationId xmlns:a16="http://schemas.microsoft.com/office/drawing/2014/main" id="{BC684343-C7BD-0598-6FA1-4F01C961D4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0672" y="2880000"/>
              <a:ext cx="535606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ca-ES" altLang="ca-ES" sz="1200" b="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Time</a:t>
              </a:r>
              <a:r>
                <a:rPr kumimoji="0" lang="ca-ES" altLang="ca-ES" sz="12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 (h)</a:t>
              </a:r>
            </a:p>
          </p:txBody>
        </p:sp>
        <p:sp>
          <p:nvSpPr>
            <p:cNvPr id="370" name="Rectangle 51">
              <a:extLst>
                <a:ext uri="{FF2B5EF4-FFF2-40B4-BE49-F238E27FC236}">
                  <a16:creationId xmlns:a16="http://schemas.microsoft.com/office/drawing/2014/main" id="{333C80AC-F0F2-847B-7657-41FB10970F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5021" y="2274461"/>
              <a:ext cx="7101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ca-ES" sz="1200" b="1" dirty="0">
                  <a:solidFill>
                    <a:schemeClr val="accent1"/>
                  </a:solidFill>
                  <a:latin typeface="Palatino Linotype" panose="02040502050505030304" pitchFamily="18" charset="0"/>
                </a:rPr>
                <a:t>a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solidFill>
                  <a:schemeClr val="accent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71" name="Rectangle 51">
              <a:extLst>
                <a:ext uri="{FF2B5EF4-FFF2-40B4-BE49-F238E27FC236}">
                  <a16:creationId xmlns:a16="http://schemas.microsoft.com/office/drawing/2014/main" id="{2B03B9C7-1387-E015-9505-DC8535C1C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2743" y="2302784"/>
              <a:ext cx="7101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ca-ES" sz="1200" b="1" dirty="0">
                  <a:solidFill>
                    <a:schemeClr val="accent1"/>
                  </a:solidFill>
                  <a:latin typeface="Palatino Linotype" panose="02040502050505030304" pitchFamily="18" charset="0"/>
                </a:rPr>
                <a:t>a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solidFill>
                  <a:schemeClr val="accent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72" name="Rectangle 51">
              <a:extLst>
                <a:ext uri="{FF2B5EF4-FFF2-40B4-BE49-F238E27FC236}">
                  <a16:creationId xmlns:a16="http://schemas.microsoft.com/office/drawing/2014/main" id="{78B57B68-9230-9579-1860-9436E0BE0E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689" y="2274461"/>
              <a:ext cx="71019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ca-ES" sz="1200" b="1" dirty="0">
                  <a:solidFill>
                    <a:schemeClr val="accent1"/>
                  </a:solidFill>
                  <a:latin typeface="Palatino Linotype" panose="02040502050505030304" pitchFamily="18" charset="0"/>
                </a:rPr>
                <a:t>a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solidFill>
                  <a:schemeClr val="accent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73" name="Rectangle 51">
              <a:extLst>
                <a:ext uri="{FF2B5EF4-FFF2-40B4-BE49-F238E27FC236}">
                  <a16:creationId xmlns:a16="http://schemas.microsoft.com/office/drawing/2014/main" id="{2183423A-6601-E155-5198-5E5C77CEF6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3724" y="2175050"/>
              <a:ext cx="193825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ca-ES" sz="1200" b="1" dirty="0" err="1">
                  <a:solidFill>
                    <a:schemeClr val="accent1"/>
                  </a:solidFill>
                  <a:latin typeface="Palatino Linotype" panose="02040502050505030304" pitchFamily="18" charset="0"/>
                </a:rPr>
                <a:t>a,b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solidFill>
                  <a:schemeClr val="accent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74" name="Rectangle 51">
              <a:extLst>
                <a:ext uri="{FF2B5EF4-FFF2-40B4-BE49-F238E27FC236}">
                  <a16:creationId xmlns:a16="http://schemas.microsoft.com/office/drawing/2014/main" id="{64469EE3-355E-4C63-9039-398AC88FD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9098" y="1895302"/>
              <a:ext cx="87296" cy="169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ca-ES" sz="1200" b="1" dirty="0">
                  <a:solidFill>
                    <a:schemeClr val="accent1"/>
                  </a:solidFill>
                  <a:latin typeface="Palatino Linotype" panose="02040502050505030304" pitchFamily="18" charset="0"/>
                </a:rPr>
                <a:t>b</a:t>
              </a:r>
              <a:endParaRPr kumimoji="0" lang="ca-ES" altLang="ca-ES" sz="1200" b="1" i="0" u="none" strike="noStrike" cap="none" normalizeH="0" baseline="0" dirty="0">
                <a:ln>
                  <a:noFill/>
                </a:ln>
                <a:solidFill>
                  <a:schemeClr val="accent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cxnSp>
          <p:nvCxnSpPr>
            <p:cNvPr id="217" name="168 Conector recto">
              <a:extLst>
                <a:ext uri="{FF2B5EF4-FFF2-40B4-BE49-F238E27FC236}">
                  <a16:creationId xmlns:a16="http://schemas.microsoft.com/office/drawing/2014/main" id="{399FF4DB-DD33-E012-882A-97BB978B99D5}"/>
                </a:ext>
              </a:extLst>
            </p:cNvPr>
            <p:cNvCxnSpPr/>
            <p:nvPr/>
          </p:nvCxnSpPr>
          <p:spPr>
            <a:xfrm>
              <a:off x="1335117" y="1257638"/>
              <a:ext cx="0" cy="12961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170 Conector recto">
              <a:extLst>
                <a:ext uri="{FF2B5EF4-FFF2-40B4-BE49-F238E27FC236}">
                  <a16:creationId xmlns:a16="http://schemas.microsoft.com/office/drawing/2014/main" id="{77B9697E-A4CD-244F-F54A-CB9E8091FB6E}"/>
                </a:ext>
              </a:extLst>
            </p:cNvPr>
            <p:cNvCxnSpPr/>
            <p:nvPr/>
          </p:nvCxnSpPr>
          <p:spPr>
            <a:xfrm flipH="1">
              <a:off x="1249907" y="2497451"/>
              <a:ext cx="22472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id="{9F2BA445-B4F6-38E9-AC08-7ED1670F1C25}"/>
                </a:ext>
              </a:extLst>
            </p:cNvPr>
            <p:cNvGrpSpPr/>
            <p:nvPr/>
          </p:nvGrpSpPr>
          <p:grpSpPr>
            <a:xfrm>
              <a:off x="1481454" y="2465427"/>
              <a:ext cx="63500" cy="65087"/>
              <a:chOff x="2263503" y="1563142"/>
              <a:chExt cx="63500" cy="65087"/>
            </a:xfrm>
          </p:grpSpPr>
          <p:sp>
            <p:nvSpPr>
              <p:cNvPr id="4" name="Freeform 167">
                <a:extLst>
                  <a:ext uri="{FF2B5EF4-FFF2-40B4-BE49-F238E27FC236}">
                    <a16:creationId xmlns:a16="http://schemas.microsoft.com/office/drawing/2014/main" id="{5221098F-0759-167A-08AF-AF7B4200815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90130"/>
                <a:ext cx="55563" cy="4762"/>
              </a:xfrm>
              <a:custGeom>
                <a:avLst/>
                <a:gdLst>
                  <a:gd name="T0" fmla="*/ 15 w 35"/>
                  <a:gd name="T1" fmla="*/ 3 h 3"/>
                  <a:gd name="T2" fmla="*/ 15 w 35"/>
                  <a:gd name="T3" fmla="*/ 2 h 3"/>
                  <a:gd name="T4" fmla="*/ 19 w 35"/>
                  <a:gd name="T5" fmla="*/ 2 h 3"/>
                  <a:gd name="T6" fmla="*/ 19 w 35"/>
                  <a:gd name="T7" fmla="*/ 3 h 3"/>
                  <a:gd name="T8" fmla="*/ 15 w 35"/>
                  <a:gd name="T9" fmla="*/ 3 h 3"/>
                  <a:gd name="T10" fmla="*/ 0 w 35"/>
                  <a:gd name="T11" fmla="*/ 0 h 3"/>
                  <a:gd name="T12" fmla="*/ 35 w 35"/>
                  <a:gd name="T13" fmla="*/ 0 h 3"/>
                  <a:gd name="T14" fmla="*/ 35 w 35"/>
                  <a:gd name="T15" fmla="*/ 3 h 3"/>
                  <a:gd name="T16" fmla="*/ 0 w 35"/>
                  <a:gd name="T17" fmla="*/ 3 h 3"/>
                  <a:gd name="T18" fmla="*/ 0 w 35"/>
                  <a:gd name="T19" fmla="*/ 0 h 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3">
                    <a:moveTo>
                      <a:pt x="15" y="3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3"/>
                    </a:lnTo>
                    <a:lnTo>
                      <a:pt x="15" y="3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" name="Freeform 172">
                <a:extLst>
                  <a:ext uri="{FF2B5EF4-FFF2-40B4-BE49-F238E27FC236}">
                    <a16:creationId xmlns:a16="http://schemas.microsoft.com/office/drawing/2014/main" id="{207CFB54-A465-2881-2B37-DC038519F21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79017"/>
                <a:ext cx="55563" cy="11112"/>
              </a:xfrm>
              <a:custGeom>
                <a:avLst/>
                <a:gdLst>
                  <a:gd name="T0" fmla="*/ 15 w 35"/>
                  <a:gd name="T1" fmla="*/ 7 h 7"/>
                  <a:gd name="T2" fmla="*/ 15 w 35"/>
                  <a:gd name="T3" fmla="*/ 2 h 7"/>
                  <a:gd name="T4" fmla="*/ 19 w 35"/>
                  <a:gd name="T5" fmla="*/ 2 h 7"/>
                  <a:gd name="T6" fmla="*/ 19 w 35"/>
                  <a:gd name="T7" fmla="*/ 7 h 7"/>
                  <a:gd name="T8" fmla="*/ 15 w 35"/>
                  <a:gd name="T9" fmla="*/ 7 h 7"/>
                  <a:gd name="T10" fmla="*/ 0 w 35"/>
                  <a:gd name="T11" fmla="*/ 0 h 7"/>
                  <a:gd name="T12" fmla="*/ 35 w 35"/>
                  <a:gd name="T13" fmla="*/ 0 h 7"/>
                  <a:gd name="T14" fmla="*/ 35 w 35"/>
                  <a:gd name="T15" fmla="*/ 4 h 7"/>
                  <a:gd name="T16" fmla="*/ 0 w 35"/>
                  <a:gd name="T17" fmla="*/ 4 h 7"/>
                  <a:gd name="T18" fmla="*/ 0 w 35"/>
                  <a:gd name="T19" fmla="*/ 0 h 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7">
                    <a:moveTo>
                      <a:pt x="15" y="7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7"/>
                    </a:lnTo>
                    <a:lnTo>
                      <a:pt x="15" y="7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" name="Oval 179">
                <a:extLst>
                  <a:ext uri="{FF2B5EF4-FFF2-40B4-BE49-F238E27FC236}">
                    <a16:creationId xmlns:a16="http://schemas.microsoft.com/office/drawing/2014/main" id="{AB312589-FA57-A9E4-E335-30A847278C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" name="Oval 180">
                <a:extLst>
                  <a:ext uri="{FF2B5EF4-FFF2-40B4-BE49-F238E27FC236}">
                    <a16:creationId xmlns:a16="http://schemas.microsoft.com/office/drawing/2014/main" id="{9EF88904-6E10-B113-96F9-5F29A418F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10" name="Grupo 9">
              <a:extLst>
                <a:ext uri="{FF2B5EF4-FFF2-40B4-BE49-F238E27FC236}">
                  <a16:creationId xmlns:a16="http://schemas.microsoft.com/office/drawing/2014/main" id="{608115AC-206C-F454-4243-B2A00E1A6F0C}"/>
                </a:ext>
              </a:extLst>
            </p:cNvPr>
            <p:cNvGrpSpPr/>
            <p:nvPr/>
          </p:nvGrpSpPr>
          <p:grpSpPr>
            <a:xfrm>
              <a:off x="1932743" y="2464773"/>
              <a:ext cx="63500" cy="65087"/>
              <a:chOff x="2263503" y="1563142"/>
              <a:chExt cx="63500" cy="65087"/>
            </a:xfrm>
          </p:grpSpPr>
          <p:sp>
            <p:nvSpPr>
              <p:cNvPr id="13" name="Freeform 167">
                <a:extLst>
                  <a:ext uri="{FF2B5EF4-FFF2-40B4-BE49-F238E27FC236}">
                    <a16:creationId xmlns:a16="http://schemas.microsoft.com/office/drawing/2014/main" id="{A3674505-C96A-F227-8457-04579EDD001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90130"/>
                <a:ext cx="55563" cy="4762"/>
              </a:xfrm>
              <a:custGeom>
                <a:avLst/>
                <a:gdLst>
                  <a:gd name="T0" fmla="*/ 15 w 35"/>
                  <a:gd name="T1" fmla="*/ 3 h 3"/>
                  <a:gd name="T2" fmla="*/ 15 w 35"/>
                  <a:gd name="T3" fmla="*/ 2 h 3"/>
                  <a:gd name="T4" fmla="*/ 19 w 35"/>
                  <a:gd name="T5" fmla="*/ 2 h 3"/>
                  <a:gd name="T6" fmla="*/ 19 w 35"/>
                  <a:gd name="T7" fmla="*/ 3 h 3"/>
                  <a:gd name="T8" fmla="*/ 15 w 35"/>
                  <a:gd name="T9" fmla="*/ 3 h 3"/>
                  <a:gd name="T10" fmla="*/ 0 w 35"/>
                  <a:gd name="T11" fmla="*/ 0 h 3"/>
                  <a:gd name="T12" fmla="*/ 35 w 35"/>
                  <a:gd name="T13" fmla="*/ 0 h 3"/>
                  <a:gd name="T14" fmla="*/ 35 w 35"/>
                  <a:gd name="T15" fmla="*/ 3 h 3"/>
                  <a:gd name="T16" fmla="*/ 0 w 35"/>
                  <a:gd name="T17" fmla="*/ 3 h 3"/>
                  <a:gd name="T18" fmla="*/ 0 w 35"/>
                  <a:gd name="T19" fmla="*/ 0 h 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3">
                    <a:moveTo>
                      <a:pt x="15" y="3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3"/>
                    </a:lnTo>
                    <a:lnTo>
                      <a:pt x="15" y="3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" name="Freeform 172">
                <a:extLst>
                  <a:ext uri="{FF2B5EF4-FFF2-40B4-BE49-F238E27FC236}">
                    <a16:creationId xmlns:a16="http://schemas.microsoft.com/office/drawing/2014/main" id="{D54E4E29-0621-8A40-A5F3-D7CF5CB61EC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79017"/>
                <a:ext cx="55563" cy="11112"/>
              </a:xfrm>
              <a:custGeom>
                <a:avLst/>
                <a:gdLst>
                  <a:gd name="T0" fmla="*/ 15 w 35"/>
                  <a:gd name="T1" fmla="*/ 7 h 7"/>
                  <a:gd name="T2" fmla="*/ 15 w 35"/>
                  <a:gd name="T3" fmla="*/ 2 h 7"/>
                  <a:gd name="T4" fmla="*/ 19 w 35"/>
                  <a:gd name="T5" fmla="*/ 2 h 7"/>
                  <a:gd name="T6" fmla="*/ 19 w 35"/>
                  <a:gd name="T7" fmla="*/ 7 h 7"/>
                  <a:gd name="T8" fmla="*/ 15 w 35"/>
                  <a:gd name="T9" fmla="*/ 7 h 7"/>
                  <a:gd name="T10" fmla="*/ 0 w 35"/>
                  <a:gd name="T11" fmla="*/ 0 h 7"/>
                  <a:gd name="T12" fmla="*/ 35 w 35"/>
                  <a:gd name="T13" fmla="*/ 0 h 7"/>
                  <a:gd name="T14" fmla="*/ 35 w 35"/>
                  <a:gd name="T15" fmla="*/ 4 h 7"/>
                  <a:gd name="T16" fmla="*/ 0 w 35"/>
                  <a:gd name="T17" fmla="*/ 4 h 7"/>
                  <a:gd name="T18" fmla="*/ 0 w 35"/>
                  <a:gd name="T19" fmla="*/ 0 h 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7">
                    <a:moveTo>
                      <a:pt x="15" y="7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7"/>
                    </a:lnTo>
                    <a:lnTo>
                      <a:pt x="15" y="7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" name="Oval 179">
                <a:extLst>
                  <a:ext uri="{FF2B5EF4-FFF2-40B4-BE49-F238E27FC236}">
                    <a16:creationId xmlns:a16="http://schemas.microsoft.com/office/drawing/2014/main" id="{CFDB5AA0-BF58-640C-67A8-99B9804082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" name="Oval 180">
                <a:extLst>
                  <a:ext uri="{FF2B5EF4-FFF2-40B4-BE49-F238E27FC236}">
                    <a16:creationId xmlns:a16="http://schemas.microsoft.com/office/drawing/2014/main" id="{C3B72C55-E0F7-0BC4-AA48-1690DE9A74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F809C3FF-13D9-BCF8-770D-82EB4212D987}"/>
                </a:ext>
              </a:extLst>
            </p:cNvPr>
            <p:cNvGrpSpPr/>
            <p:nvPr/>
          </p:nvGrpSpPr>
          <p:grpSpPr>
            <a:xfrm>
              <a:off x="2373518" y="2459282"/>
              <a:ext cx="63500" cy="65087"/>
              <a:chOff x="2263503" y="1563142"/>
              <a:chExt cx="63500" cy="65087"/>
            </a:xfrm>
          </p:grpSpPr>
          <p:sp>
            <p:nvSpPr>
              <p:cNvPr id="18" name="Freeform 167">
                <a:extLst>
                  <a:ext uri="{FF2B5EF4-FFF2-40B4-BE49-F238E27FC236}">
                    <a16:creationId xmlns:a16="http://schemas.microsoft.com/office/drawing/2014/main" id="{9234DA9E-9BF2-AF83-EFBC-9A9E009EA44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90130"/>
                <a:ext cx="55563" cy="4762"/>
              </a:xfrm>
              <a:custGeom>
                <a:avLst/>
                <a:gdLst>
                  <a:gd name="T0" fmla="*/ 15 w 35"/>
                  <a:gd name="T1" fmla="*/ 3 h 3"/>
                  <a:gd name="T2" fmla="*/ 15 w 35"/>
                  <a:gd name="T3" fmla="*/ 2 h 3"/>
                  <a:gd name="T4" fmla="*/ 19 w 35"/>
                  <a:gd name="T5" fmla="*/ 2 h 3"/>
                  <a:gd name="T6" fmla="*/ 19 w 35"/>
                  <a:gd name="T7" fmla="*/ 3 h 3"/>
                  <a:gd name="T8" fmla="*/ 15 w 35"/>
                  <a:gd name="T9" fmla="*/ 3 h 3"/>
                  <a:gd name="T10" fmla="*/ 0 w 35"/>
                  <a:gd name="T11" fmla="*/ 0 h 3"/>
                  <a:gd name="T12" fmla="*/ 35 w 35"/>
                  <a:gd name="T13" fmla="*/ 0 h 3"/>
                  <a:gd name="T14" fmla="*/ 35 w 35"/>
                  <a:gd name="T15" fmla="*/ 3 h 3"/>
                  <a:gd name="T16" fmla="*/ 0 w 35"/>
                  <a:gd name="T17" fmla="*/ 3 h 3"/>
                  <a:gd name="T18" fmla="*/ 0 w 35"/>
                  <a:gd name="T19" fmla="*/ 0 h 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3">
                    <a:moveTo>
                      <a:pt x="15" y="3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3"/>
                    </a:lnTo>
                    <a:lnTo>
                      <a:pt x="15" y="3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" name="Freeform 172">
                <a:extLst>
                  <a:ext uri="{FF2B5EF4-FFF2-40B4-BE49-F238E27FC236}">
                    <a16:creationId xmlns:a16="http://schemas.microsoft.com/office/drawing/2014/main" id="{21C097AB-41BB-5F64-050D-E2B303BF473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268265" y="1579017"/>
                <a:ext cx="55563" cy="11112"/>
              </a:xfrm>
              <a:custGeom>
                <a:avLst/>
                <a:gdLst>
                  <a:gd name="T0" fmla="*/ 15 w 35"/>
                  <a:gd name="T1" fmla="*/ 7 h 7"/>
                  <a:gd name="T2" fmla="*/ 15 w 35"/>
                  <a:gd name="T3" fmla="*/ 2 h 7"/>
                  <a:gd name="T4" fmla="*/ 19 w 35"/>
                  <a:gd name="T5" fmla="*/ 2 h 7"/>
                  <a:gd name="T6" fmla="*/ 19 w 35"/>
                  <a:gd name="T7" fmla="*/ 7 h 7"/>
                  <a:gd name="T8" fmla="*/ 15 w 35"/>
                  <a:gd name="T9" fmla="*/ 7 h 7"/>
                  <a:gd name="T10" fmla="*/ 0 w 35"/>
                  <a:gd name="T11" fmla="*/ 0 h 7"/>
                  <a:gd name="T12" fmla="*/ 35 w 35"/>
                  <a:gd name="T13" fmla="*/ 0 h 7"/>
                  <a:gd name="T14" fmla="*/ 35 w 35"/>
                  <a:gd name="T15" fmla="*/ 4 h 7"/>
                  <a:gd name="T16" fmla="*/ 0 w 35"/>
                  <a:gd name="T17" fmla="*/ 4 h 7"/>
                  <a:gd name="T18" fmla="*/ 0 w 35"/>
                  <a:gd name="T19" fmla="*/ 0 h 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7">
                    <a:moveTo>
                      <a:pt x="15" y="7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7"/>
                    </a:lnTo>
                    <a:lnTo>
                      <a:pt x="15" y="7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" name="Oval 179">
                <a:extLst>
                  <a:ext uri="{FF2B5EF4-FFF2-40B4-BE49-F238E27FC236}">
                    <a16:creationId xmlns:a16="http://schemas.microsoft.com/office/drawing/2014/main" id="{4133590D-FC27-4A92-B81E-70942AE6D0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" name="Oval 180">
                <a:extLst>
                  <a:ext uri="{FF2B5EF4-FFF2-40B4-BE49-F238E27FC236}">
                    <a16:creationId xmlns:a16="http://schemas.microsoft.com/office/drawing/2014/main" id="{B6459227-D04E-AC97-F303-0B6E6C488D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3503" y="1563142"/>
                <a:ext cx="63500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22" name="Rectangle 46">
              <a:extLst>
                <a:ext uri="{FF2B5EF4-FFF2-40B4-BE49-F238E27FC236}">
                  <a16:creationId xmlns:a16="http://schemas.microsoft.com/office/drawing/2014/main" id="{5A085B87-88C2-FE3B-01F7-6FC7EF4DC8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125" y="552838"/>
              <a:ext cx="3268691" cy="339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228600" indent="-228600">
                <a:buFont typeface="+mj-lt"/>
                <a:buAutoNum type="alphaLcParenR"/>
              </a:pPr>
              <a:r>
                <a:rPr kumimoji="0" lang="ca-ES" altLang="ca-ES" sz="1200" b="1" i="0" u="none" strike="noStrike" cap="none" normalizeH="0" dirty="0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</a:rPr>
                <a:t>5-(3’,4’-Dihydroxyphenyl)-</a:t>
              </a:r>
              <a:r>
                <a:rPr kumimoji="0" lang="ca-ES" altLang="ca-ES" sz="1200" b="1" i="0" u="none" strike="noStrike" cap="none" normalizeH="0" dirty="0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  <a:sym typeface="Symbol" panose="05050102010706020507" pitchFamily="18" charset="2"/>
                </a:rPr>
                <a:t> -</a:t>
              </a:r>
              <a:r>
                <a:rPr kumimoji="0" lang="ca-ES" altLang="ca-ES" sz="1200" b="1" i="0" u="none" strike="noStrike" cap="none" normalizeH="0" dirty="0" err="1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  <a:sym typeface="Symbol" panose="05050102010706020507" pitchFamily="18" charset="2"/>
                </a:rPr>
                <a:t>valerolactone</a:t>
              </a:r>
              <a:r>
                <a:rPr kumimoji="0" lang="ca-ES" altLang="ca-ES" sz="1200" b="1" i="0" u="none" strike="noStrike" cap="none" normalizeH="0" dirty="0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</a:rPr>
                <a:t>-</a:t>
              </a:r>
              <a:r>
                <a:rPr kumimoji="0" lang="ca-ES" altLang="ca-ES" sz="1200" b="1" i="1" u="none" strike="noStrike" cap="none" normalizeH="0" dirty="0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</a:rPr>
                <a:t>O</a:t>
              </a:r>
              <a:r>
                <a:rPr kumimoji="0" lang="ca-ES" altLang="ca-ES" sz="1200" b="1" i="0" u="none" strike="noStrike" cap="none" normalizeH="0" dirty="0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</a:rPr>
                <a:t>-</a:t>
              </a:r>
              <a:r>
                <a:rPr kumimoji="0" lang="ca-ES" altLang="ca-ES" sz="1200" b="1" i="0" u="none" strike="noStrike" cap="none" normalizeH="0" dirty="0" err="1">
                  <a:ln>
                    <a:noFill/>
                  </a:ln>
                  <a:effectLst/>
                  <a:latin typeface="Palatino Linotype" panose="02040502050505030304" pitchFamily="18" charset="0"/>
                  <a:ea typeface="Calibri"/>
                  <a:cs typeface="Arial"/>
                </a:rPr>
                <a:t>glucuronide</a:t>
              </a:r>
              <a:r>
                <a:rPr lang="ca-ES" altLang="ca-ES" sz="1200" b="1" dirty="0">
                  <a:latin typeface="Palatino Linotype" panose="02040502050505030304" pitchFamily="18" charset="0"/>
                  <a:ea typeface="Calibri"/>
                  <a:cs typeface="Arial"/>
                </a:rPr>
                <a:t>, N=4 (36,4%)</a:t>
              </a:r>
              <a:endParaRPr lang="ca-ES" altLang="ca-ES" sz="1200" b="1" i="0" u="none" strike="noStrike" cap="none" normalizeH="0" baseline="0" dirty="0">
                <a:ln>
                  <a:noFill/>
                </a:ln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23" name="Rectangle 213">
              <a:extLst>
                <a:ext uri="{FF2B5EF4-FFF2-40B4-BE49-F238E27FC236}">
                  <a16:creationId xmlns:a16="http://schemas.microsoft.com/office/drawing/2014/main" id="{FB3B42D6-44DE-6831-D5B6-C5807540E80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13653" y="1819057"/>
              <a:ext cx="1237735" cy="1704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ca-ES" altLang="ca-ES" sz="1200" dirty="0" err="1">
                  <a:latin typeface="Palatino Linotype" panose="02040502050505030304" pitchFamily="18" charset="0"/>
                </a:rPr>
                <a:t>Concentration</a:t>
              </a:r>
              <a:r>
                <a:rPr lang="ca-ES" altLang="ca-ES" sz="1200" dirty="0">
                  <a:latin typeface="Palatino Linotype" panose="02040502050505030304" pitchFamily="18" charset="0"/>
                </a:rPr>
                <a:t> </a:t>
              </a:r>
              <a:r>
                <a:rPr kumimoji="0" lang="ca-ES" altLang="ca-ES" sz="12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(</a:t>
              </a:r>
              <a:r>
                <a:rPr kumimoji="0" lang="ca-ES" altLang="ca-ES" sz="1200" b="0" i="0" u="none" strike="noStrike" cap="none" normalizeH="0" baseline="0" dirty="0" err="1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nM</a:t>
              </a:r>
              <a:r>
                <a:rPr kumimoji="0" lang="ca-ES" altLang="ca-ES" sz="1200" b="0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rPr>
                <a:t>)</a:t>
              </a:r>
            </a:p>
          </p:txBody>
        </p:sp>
        <p:grpSp>
          <p:nvGrpSpPr>
            <p:cNvPr id="8" name="Agrupa 7">
              <a:extLst>
                <a:ext uri="{FF2B5EF4-FFF2-40B4-BE49-F238E27FC236}">
                  <a16:creationId xmlns:a16="http://schemas.microsoft.com/office/drawing/2014/main" id="{04F26BFB-0A14-90DE-7BE3-8E3F8A64BEFA}"/>
                </a:ext>
              </a:extLst>
            </p:cNvPr>
            <p:cNvGrpSpPr/>
            <p:nvPr/>
          </p:nvGrpSpPr>
          <p:grpSpPr>
            <a:xfrm>
              <a:off x="4567439" y="548680"/>
              <a:ext cx="3432655" cy="2501067"/>
              <a:chOff x="5064771" y="548680"/>
              <a:chExt cx="3432655" cy="2501067"/>
            </a:xfrm>
          </p:grpSpPr>
          <p:sp>
            <p:nvSpPr>
              <p:cNvPr id="245" name="Rectangle 345">
                <a:extLst>
                  <a:ext uri="{FF2B5EF4-FFF2-40B4-BE49-F238E27FC236}">
                    <a16:creationId xmlns:a16="http://schemas.microsoft.com/office/drawing/2014/main" id="{7C515775-0F43-A2E5-69D2-5E46C2AA53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6866" y="2487727"/>
                <a:ext cx="2248342" cy="7937"/>
              </a:xfrm>
              <a:prstGeom prst="rect">
                <a:avLst/>
              </a:prstGeom>
              <a:solidFill>
                <a:srgbClr val="D9D9D9"/>
              </a:solidFill>
              <a:ln w="1588" cap="flat">
                <a:solidFill>
                  <a:srgbClr val="D9D9D9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7" name="Freeform 347">
                <a:extLst>
                  <a:ext uri="{FF2B5EF4-FFF2-40B4-BE49-F238E27FC236}">
                    <a16:creationId xmlns:a16="http://schemas.microsoft.com/office/drawing/2014/main" id="{A65417C0-300D-FFF8-A4A6-67B5C21DDEF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322578" y="2248015"/>
                <a:ext cx="59911" cy="68262"/>
              </a:xfrm>
              <a:custGeom>
                <a:avLst/>
                <a:gdLst>
                  <a:gd name="T0" fmla="*/ 16 w 36"/>
                  <a:gd name="T1" fmla="*/ 43 h 43"/>
                  <a:gd name="T2" fmla="*/ 16 w 36"/>
                  <a:gd name="T3" fmla="*/ 2 h 43"/>
                  <a:gd name="T4" fmla="*/ 20 w 36"/>
                  <a:gd name="T5" fmla="*/ 2 h 43"/>
                  <a:gd name="T6" fmla="*/ 20 w 36"/>
                  <a:gd name="T7" fmla="*/ 43 h 43"/>
                  <a:gd name="T8" fmla="*/ 16 w 36"/>
                  <a:gd name="T9" fmla="*/ 43 h 43"/>
                  <a:gd name="T10" fmla="*/ 0 w 36"/>
                  <a:gd name="T11" fmla="*/ 0 h 43"/>
                  <a:gd name="T12" fmla="*/ 36 w 36"/>
                  <a:gd name="T13" fmla="*/ 0 h 43"/>
                  <a:gd name="T14" fmla="*/ 36 w 36"/>
                  <a:gd name="T15" fmla="*/ 4 h 43"/>
                  <a:gd name="T16" fmla="*/ 0 w 36"/>
                  <a:gd name="T17" fmla="*/ 4 h 43"/>
                  <a:gd name="T18" fmla="*/ 0 w 36"/>
                  <a:gd name="T19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43">
                    <a:moveTo>
                      <a:pt x="16" y="43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43"/>
                    </a:lnTo>
                    <a:lnTo>
                      <a:pt x="16" y="4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8" name="Freeform 348">
                <a:extLst>
                  <a:ext uri="{FF2B5EF4-FFF2-40B4-BE49-F238E27FC236}">
                    <a16:creationId xmlns:a16="http://schemas.microsoft.com/office/drawing/2014/main" id="{8DA8E7BA-18EC-F55E-86CE-914B79103DA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71913" y="2321040"/>
                <a:ext cx="59911" cy="36512"/>
              </a:xfrm>
              <a:custGeom>
                <a:avLst/>
                <a:gdLst>
                  <a:gd name="T0" fmla="*/ 16 w 36"/>
                  <a:gd name="T1" fmla="*/ 23 h 23"/>
                  <a:gd name="T2" fmla="*/ 16 w 36"/>
                  <a:gd name="T3" fmla="*/ 2 h 23"/>
                  <a:gd name="T4" fmla="*/ 20 w 36"/>
                  <a:gd name="T5" fmla="*/ 2 h 23"/>
                  <a:gd name="T6" fmla="*/ 20 w 36"/>
                  <a:gd name="T7" fmla="*/ 23 h 23"/>
                  <a:gd name="T8" fmla="*/ 16 w 36"/>
                  <a:gd name="T9" fmla="*/ 23 h 23"/>
                  <a:gd name="T10" fmla="*/ 0 w 36"/>
                  <a:gd name="T11" fmla="*/ 0 h 23"/>
                  <a:gd name="T12" fmla="*/ 36 w 36"/>
                  <a:gd name="T13" fmla="*/ 0 h 23"/>
                  <a:gd name="T14" fmla="*/ 36 w 36"/>
                  <a:gd name="T15" fmla="*/ 4 h 23"/>
                  <a:gd name="T16" fmla="*/ 0 w 36"/>
                  <a:gd name="T17" fmla="*/ 4 h 23"/>
                  <a:gd name="T18" fmla="*/ 0 w 36"/>
                  <a:gd name="T1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23">
                    <a:moveTo>
                      <a:pt x="16" y="23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23"/>
                    </a:lnTo>
                    <a:lnTo>
                      <a:pt x="16" y="2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9" name="Freeform 349">
                <a:extLst>
                  <a:ext uri="{FF2B5EF4-FFF2-40B4-BE49-F238E27FC236}">
                    <a16:creationId xmlns:a16="http://schemas.microsoft.com/office/drawing/2014/main" id="{CA3BA5C5-6617-A9F5-A56B-0CE5B22E1713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221249" y="1987665"/>
                <a:ext cx="61576" cy="157162"/>
              </a:xfrm>
              <a:custGeom>
                <a:avLst/>
                <a:gdLst>
                  <a:gd name="T0" fmla="*/ 16 w 37"/>
                  <a:gd name="T1" fmla="*/ 99 h 99"/>
                  <a:gd name="T2" fmla="*/ 16 w 37"/>
                  <a:gd name="T3" fmla="*/ 2 h 99"/>
                  <a:gd name="T4" fmla="*/ 20 w 37"/>
                  <a:gd name="T5" fmla="*/ 2 h 99"/>
                  <a:gd name="T6" fmla="*/ 20 w 37"/>
                  <a:gd name="T7" fmla="*/ 99 h 99"/>
                  <a:gd name="T8" fmla="*/ 16 w 37"/>
                  <a:gd name="T9" fmla="*/ 99 h 99"/>
                  <a:gd name="T10" fmla="*/ 0 w 37"/>
                  <a:gd name="T11" fmla="*/ 0 h 99"/>
                  <a:gd name="T12" fmla="*/ 37 w 37"/>
                  <a:gd name="T13" fmla="*/ 0 h 99"/>
                  <a:gd name="T14" fmla="*/ 37 w 37"/>
                  <a:gd name="T15" fmla="*/ 3 h 99"/>
                  <a:gd name="T16" fmla="*/ 0 w 37"/>
                  <a:gd name="T17" fmla="*/ 3 h 99"/>
                  <a:gd name="T18" fmla="*/ 0 w 37"/>
                  <a:gd name="T19" fmla="*/ 0 h 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99">
                    <a:moveTo>
                      <a:pt x="16" y="99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99"/>
                    </a:lnTo>
                    <a:lnTo>
                      <a:pt x="16" y="99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0" name="Freeform 350">
                <a:extLst>
                  <a:ext uri="{FF2B5EF4-FFF2-40B4-BE49-F238E27FC236}">
                    <a16:creationId xmlns:a16="http://schemas.microsoft.com/office/drawing/2014/main" id="{E05F8A3F-A551-1577-16D7-BB4871AE6477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672249" y="1532052"/>
                <a:ext cx="58248" cy="209550"/>
              </a:xfrm>
              <a:custGeom>
                <a:avLst/>
                <a:gdLst>
                  <a:gd name="T0" fmla="*/ 15 w 35"/>
                  <a:gd name="T1" fmla="*/ 132 h 132"/>
                  <a:gd name="T2" fmla="*/ 15 w 35"/>
                  <a:gd name="T3" fmla="*/ 2 h 132"/>
                  <a:gd name="T4" fmla="*/ 19 w 35"/>
                  <a:gd name="T5" fmla="*/ 2 h 132"/>
                  <a:gd name="T6" fmla="*/ 19 w 35"/>
                  <a:gd name="T7" fmla="*/ 132 h 132"/>
                  <a:gd name="T8" fmla="*/ 15 w 35"/>
                  <a:gd name="T9" fmla="*/ 132 h 132"/>
                  <a:gd name="T10" fmla="*/ 0 w 35"/>
                  <a:gd name="T11" fmla="*/ 0 h 132"/>
                  <a:gd name="T12" fmla="*/ 35 w 35"/>
                  <a:gd name="T13" fmla="*/ 0 h 132"/>
                  <a:gd name="T14" fmla="*/ 35 w 35"/>
                  <a:gd name="T15" fmla="*/ 4 h 132"/>
                  <a:gd name="T16" fmla="*/ 0 w 35"/>
                  <a:gd name="T17" fmla="*/ 4 h 132"/>
                  <a:gd name="T18" fmla="*/ 0 w 35"/>
                  <a:gd name="T19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32">
                    <a:moveTo>
                      <a:pt x="15" y="132"/>
                    </a:moveTo>
                    <a:lnTo>
                      <a:pt x="15" y="2"/>
                    </a:lnTo>
                    <a:lnTo>
                      <a:pt x="19" y="2"/>
                    </a:lnTo>
                    <a:lnTo>
                      <a:pt x="19" y="132"/>
                    </a:lnTo>
                    <a:lnTo>
                      <a:pt x="15" y="132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1" name="Freeform 351">
                <a:extLst>
                  <a:ext uri="{FF2B5EF4-FFF2-40B4-BE49-F238E27FC236}">
                    <a16:creationId xmlns:a16="http://schemas.microsoft.com/office/drawing/2014/main" id="{015495A8-100D-9A77-4A4B-A1B4E491C328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871579" y="2236902"/>
                <a:ext cx="59911" cy="93662"/>
              </a:xfrm>
              <a:custGeom>
                <a:avLst/>
                <a:gdLst>
                  <a:gd name="T0" fmla="*/ 16 w 36"/>
                  <a:gd name="T1" fmla="*/ 59 h 59"/>
                  <a:gd name="T2" fmla="*/ 16 w 36"/>
                  <a:gd name="T3" fmla="*/ 2 h 59"/>
                  <a:gd name="T4" fmla="*/ 20 w 36"/>
                  <a:gd name="T5" fmla="*/ 2 h 59"/>
                  <a:gd name="T6" fmla="*/ 20 w 36"/>
                  <a:gd name="T7" fmla="*/ 59 h 59"/>
                  <a:gd name="T8" fmla="*/ 16 w 36"/>
                  <a:gd name="T9" fmla="*/ 59 h 59"/>
                  <a:gd name="T10" fmla="*/ 0 w 36"/>
                  <a:gd name="T11" fmla="*/ 0 h 59"/>
                  <a:gd name="T12" fmla="*/ 36 w 36"/>
                  <a:gd name="T13" fmla="*/ 0 h 59"/>
                  <a:gd name="T14" fmla="*/ 36 w 36"/>
                  <a:gd name="T15" fmla="*/ 4 h 59"/>
                  <a:gd name="T16" fmla="*/ 0 w 36"/>
                  <a:gd name="T17" fmla="*/ 4 h 59"/>
                  <a:gd name="T18" fmla="*/ 0 w 36"/>
                  <a:gd name="T19" fmla="*/ 0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59">
                    <a:moveTo>
                      <a:pt x="16" y="59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59"/>
                    </a:lnTo>
                    <a:lnTo>
                      <a:pt x="16" y="5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3" name="Freeform 353">
                <a:extLst>
                  <a:ext uri="{FF2B5EF4-FFF2-40B4-BE49-F238E27FC236}">
                    <a16:creationId xmlns:a16="http://schemas.microsoft.com/office/drawing/2014/main" id="{4873FDF3-9E1C-91B6-4571-0CEC1934B782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71913" y="2324215"/>
                <a:ext cx="59911" cy="47625"/>
              </a:xfrm>
              <a:custGeom>
                <a:avLst/>
                <a:gdLst>
                  <a:gd name="T0" fmla="*/ 16 w 36"/>
                  <a:gd name="T1" fmla="*/ 30 h 30"/>
                  <a:gd name="T2" fmla="*/ 16 w 36"/>
                  <a:gd name="T3" fmla="*/ 2 h 30"/>
                  <a:gd name="T4" fmla="*/ 20 w 36"/>
                  <a:gd name="T5" fmla="*/ 2 h 30"/>
                  <a:gd name="T6" fmla="*/ 20 w 36"/>
                  <a:gd name="T7" fmla="*/ 30 h 30"/>
                  <a:gd name="T8" fmla="*/ 16 w 36"/>
                  <a:gd name="T9" fmla="*/ 30 h 30"/>
                  <a:gd name="T10" fmla="*/ 0 w 36"/>
                  <a:gd name="T11" fmla="*/ 0 h 30"/>
                  <a:gd name="T12" fmla="*/ 36 w 36"/>
                  <a:gd name="T13" fmla="*/ 0 h 30"/>
                  <a:gd name="T14" fmla="*/ 36 w 36"/>
                  <a:gd name="T15" fmla="*/ 4 h 30"/>
                  <a:gd name="T16" fmla="*/ 0 w 36"/>
                  <a:gd name="T17" fmla="*/ 4 h 30"/>
                  <a:gd name="T18" fmla="*/ 0 w 36"/>
                  <a:gd name="T19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30">
                    <a:moveTo>
                      <a:pt x="16" y="30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30"/>
                    </a:lnTo>
                    <a:lnTo>
                      <a:pt x="16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6" name="Freeform 356">
                <a:extLst>
                  <a:ext uri="{FF2B5EF4-FFF2-40B4-BE49-F238E27FC236}">
                    <a16:creationId xmlns:a16="http://schemas.microsoft.com/office/drawing/2014/main" id="{267AEECE-6E85-BEFC-5220-6085756DCD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886556" y="1725727"/>
                <a:ext cx="1830626" cy="646112"/>
              </a:xfrm>
              <a:custGeom>
                <a:avLst/>
                <a:gdLst>
                  <a:gd name="T0" fmla="*/ 142 w 18322"/>
                  <a:gd name="T1" fmla="*/ 6192 h 6769"/>
                  <a:gd name="T2" fmla="*/ 4654 w 18322"/>
                  <a:gd name="T3" fmla="*/ 6048 h 6769"/>
                  <a:gd name="T4" fmla="*/ 9168 w 18322"/>
                  <a:gd name="T5" fmla="*/ 6480 h 6769"/>
                  <a:gd name="T6" fmla="*/ 9090 w 18322"/>
                  <a:gd name="T7" fmla="*/ 6494 h 6769"/>
                  <a:gd name="T8" fmla="*/ 13602 w 18322"/>
                  <a:gd name="T9" fmla="*/ 4254 h 6769"/>
                  <a:gd name="T10" fmla="*/ 13568 w 18322"/>
                  <a:gd name="T11" fmla="*/ 4279 h 6769"/>
                  <a:gd name="T12" fmla="*/ 18064 w 18322"/>
                  <a:gd name="T13" fmla="*/ 55 h 6769"/>
                  <a:gd name="T14" fmla="*/ 18267 w 18322"/>
                  <a:gd name="T15" fmla="*/ 61 h 6769"/>
                  <a:gd name="T16" fmla="*/ 18261 w 18322"/>
                  <a:gd name="T17" fmla="*/ 264 h 6769"/>
                  <a:gd name="T18" fmla="*/ 13765 w 18322"/>
                  <a:gd name="T19" fmla="*/ 4488 h 6769"/>
                  <a:gd name="T20" fmla="*/ 13731 w 18322"/>
                  <a:gd name="T21" fmla="*/ 4512 h 6769"/>
                  <a:gd name="T22" fmla="*/ 9219 w 18322"/>
                  <a:gd name="T23" fmla="*/ 6752 h 6769"/>
                  <a:gd name="T24" fmla="*/ 9141 w 18322"/>
                  <a:gd name="T25" fmla="*/ 6767 h 6769"/>
                  <a:gd name="T26" fmla="*/ 4663 w 18322"/>
                  <a:gd name="T27" fmla="*/ 6335 h 6769"/>
                  <a:gd name="T28" fmla="*/ 151 w 18322"/>
                  <a:gd name="T29" fmla="*/ 6479 h 6769"/>
                  <a:gd name="T30" fmla="*/ 3 w 18322"/>
                  <a:gd name="T31" fmla="*/ 6340 h 6769"/>
                  <a:gd name="T32" fmla="*/ 142 w 18322"/>
                  <a:gd name="T33" fmla="*/ 6192 h 67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8322" h="6769">
                    <a:moveTo>
                      <a:pt x="142" y="6192"/>
                    </a:moveTo>
                    <a:lnTo>
                      <a:pt x="4654" y="6048"/>
                    </a:lnTo>
                    <a:lnTo>
                      <a:pt x="9168" y="6480"/>
                    </a:lnTo>
                    <a:lnTo>
                      <a:pt x="9090" y="6494"/>
                    </a:lnTo>
                    <a:lnTo>
                      <a:pt x="13602" y="4254"/>
                    </a:lnTo>
                    <a:lnTo>
                      <a:pt x="13568" y="4279"/>
                    </a:lnTo>
                    <a:lnTo>
                      <a:pt x="18064" y="55"/>
                    </a:lnTo>
                    <a:cubicBezTo>
                      <a:pt x="18122" y="0"/>
                      <a:pt x="18213" y="3"/>
                      <a:pt x="18267" y="61"/>
                    </a:cubicBezTo>
                    <a:cubicBezTo>
                      <a:pt x="18322" y="119"/>
                      <a:pt x="18319" y="210"/>
                      <a:pt x="18261" y="264"/>
                    </a:cubicBezTo>
                    <a:lnTo>
                      <a:pt x="13765" y="4488"/>
                    </a:lnTo>
                    <a:cubicBezTo>
                      <a:pt x="13755" y="4498"/>
                      <a:pt x="13743" y="4506"/>
                      <a:pt x="13731" y="4512"/>
                    </a:cubicBezTo>
                    <a:lnTo>
                      <a:pt x="9219" y="6752"/>
                    </a:lnTo>
                    <a:cubicBezTo>
                      <a:pt x="9194" y="6764"/>
                      <a:pt x="9167" y="6769"/>
                      <a:pt x="9141" y="6767"/>
                    </a:cubicBezTo>
                    <a:lnTo>
                      <a:pt x="4663" y="6335"/>
                    </a:lnTo>
                    <a:lnTo>
                      <a:pt x="151" y="6479"/>
                    </a:lnTo>
                    <a:cubicBezTo>
                      <a:pt x="72" y="6482"/>
                      <a:pt x="5" y="6420"/>
                      <a:pt x="3" y="6340"/>
                    </a:cubicBezTo>
                    <a:cubicBezTo>
                      <a:pt x="0" y="6261"/>
                      <a:pt x="62" y="6194"/>
                      <a:pt x="142" y="6192"/>
                    </a:cubicBezTo>
                    <a:close/>
                  </a:path>
                </a:pathLst>
              </a:custGeom>
              <a:solidFill>
                <a:srgbClr val="5B9BD5"/>
              </a:solidFill>
              <a:ln w="1588" cap="flat">
                <a:solidFill>
                  <a:srgbClr val="5B9BD5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7" name="Oval 357">
                <a:extLst>
                  <a:ext uri="{FF2B5EF4-FFF2-40B4-BE49-F238E27FC236}">
                    <a16:creationId xmlns:a16="http://schemas.microsoft.com/office/drawing/2014/main" id="{1DBC467C-F35D-3CB1-7EA1-EF0C6D9ABC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8250" y="2297227"/>
                <a:ext cx="66568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8" name="Oval 358">
                <a:extLst>
                  <a:ext uri="{FF2B5EF4-FFF2-40B4-BE49-F238E27FC236}">
                    <a16:creationId xmlns:a16="http://schemas.microsoft.com/office/drawing/2014/main" id="{79CCAEA2-1DEA-EEFB-F9FF-78F2D3A556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8250" y="2297227"/>
                <a:ext cx="66568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9" name="Oval 359">
                <a:extLst>
                  <a:ext uri="{FF2B5EF4-FFF2-40B4-BE49-F238E27FC236}">
                    <a16:creationId xmlns:a16="http://schemas.microsoft.com/office/drawing/2014/main" id="{A0F1EA01-9C62-ACCD-E279-3C429A5B77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7586" y="2282940"/>
                <a:ext cx="66568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0" name="Oval 360">
                <a:extLst>
                  <a:ext uri="{FF2B5EF4-FFF2-40B4-BE49-F238E27FC236}">
                    <a16:creationId xmlns:a16="http://schemas.microsoft.com/office/drawing/2014/main" id="{7D8296CB-EA26-5133-17A6-09E4739E4C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17586" y="2282940"/>
                <a:ext cx="66568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1" name="Oval 361">
                <a:extLst>
                  <a:ext uri="{FF2B5EF4-FFF2-40B4-BE49-F238E27FC236}">
                    <a16:creationId xmlns:a16="http://schemas.microsoft.com/office/drawing/2014/main" id="{9ECB319B-9E12-FBDF-1457-16F097A267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68585" y="2325802"/>
                <a:ext cx="66568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2" name="Oval 362">
                <a:extLst>
                  <a:ext uri="{FF2B5EF4-FFF2-40B4-BE49-F238E27FC236}">
                    <a16:creationId xmlns:a16="http://schemas.microsoft.com/office/drawing/2014/main" id="{4134E697-82BA-7BBB-C954-BC6B43B58F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68585" y="2325802"/>
                <a:ext cx="66568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3" name="Oval 363">
                <a:extLst>
                  <a:ext uri="{FF2B5EF4-FFF2-40B4-BE49-F238E27FC236}">
                    <a16:creationId xmlns:a16="http://schemas.microsoft.com/office/drawing/2014/main" id="{086E834F-460E-B5E3-AA69-709B2004B8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6256" y="2109902"/>
                <a:ext cx="68233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4" name="Oval 364">
                <a:extLst>
                  <a:ext uri="{FF2B5EF4-FFF2-40B4-BE49-F238E27FC236}">
                    <a16:creationId xmlns:a16="http://schemas.microsoft.com/office/drawing/2014/main" id="{C34CCA93-148D-AED5-1428-F087FDE64A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6256" y="2109902"/>
                <a:ext cx="68233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5" name="Oval 365">
                <a:extLst>
                  <a:ext uri="{FF2B5EF4-FFF2-40B4-BE49-F238E27FC236}">
                    <a16:creationId xmlns:a16="http://schemas.microsoft.com/office/drawing/2014/main" id="{7616E546-CAC4-0C62-945C-44C8843D0F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67256" y="1709852"/>
                <a:ext cx="66568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6" name="Oval 366">
                <a:extLst>
                  <a:ext uri="{FF2B5EF4-FFF2-40B4-BE49-F238E27FC236}">
                    <a16:creationId xmlns:a16="http://schemas.microsoft.com/office/drawing/2014/main" id="{C9F60F49-0504-07E2-A5E7-C15C8F72DE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67256" y="1709852"/>
                <a:ext cx="66568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8" name="Rectangle 378">
                <a:extLst>
                  <a:ext uri="{FF2B5EF4-FFF2-40B4-BE49-F238E27FC236}">
                    <a16:creationId xmlns:a16="http://schemas.microsoft.com/office/drawing/2014/main" id="{CC859C98-0206-9FBB-50A4-F0A0D47ED1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05453" y="2414702"/>
                <a:ext cx="7101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0</a:t>
                </a:r>
              </a:p>
            </p:txBody>
          </p:sp>
          <p:sp>
            <p:nvSpPr>
              <p:cNvPr id="279" name="Rectangle 379">
                <a:extLst>
                  <a:ext uri="{FF2B5EF4-FFF2-40B4-BE49-F238E27FC236}">
                    <a16:creationId xmlns:a16="http://schemas.microsoft.com/office/drawing/2014/main" id="{33FD01F6-A83C-7995-C023-D5632E0515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2225790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100</a:t>
                </a:r>
              </a:p>
            </p:txBody>
          </p:sp>
          <p:sp>
            <p:nvSpPr>
              <p:cNvPr id="280" name="Rectangle 380">
                <a:extLst>
                  <a:ext uri="{FF2B5EF4-FFF2-40B4-BE49-F238E27FC236}">
                    <a16:creationId xmlns:a16="http://schemas.microsoft.com/office/drawing/2014/main" id="{E8970E18-2B7A-EB87-7CF3-0F1813FA8C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2035290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00</a:t>
                </a:r>
              </a:p>
            </p:txBody>
          </p:sp>
          <p:sp>
            <p:nvSpPr>
              <p:cNvPr id="281" name="Rectangle 381">
                <a:extLst>
                  <a:ext uri="{FF2B5EF4-FFF2-40B4-BE49-F238E27FC236}">
                    <a16:creationId xmlns:a16="http://schemas.microsoft.com/office/drawing/2014/main" id="{CB656C15-DD25-DBE9-1755-A6444DE7D1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1846377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300</a:t>
                </a:r>
              </a:p>
            </p:txBody>
          </p:sp>
          <p:sp>
            <p:nvSpPr>
              <p:cNvPr id="282" name="Rectangle 382">
                <a:extLst>
                  <a:ext uri="{FF2B5EF4-FFF2-40B4-BE49-F238E27FC236}">
                    <a16:creationId xmlns:a16="http://schemas.microsoft.com/office/drawing/2014/main" id="{F7B177C2-5668-B309-512A-BE9FB6E08D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1657465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400</a:t>
                </a:r>
              </a:p>
            </p:txBody>
          </p:sp>
          <p:sp>
            <p:nvSpPr>
              <p:cNvPr id="283" name="Rectangle 383">
                <a:extLst>
                  <a:ext uri="{FF2B5EF4-FFF2-40B4-BE49-F238E27FC236}">
                    <a16:creationId xmlns:a16="http://schemas.microsoft.com/office/drawing/2014/main" id="{A118EAB7-3A5F-72EF-6100-000BDA8645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1466965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500</a:t>
                </a:r>
              </a:p>
            </p:txBody>
          </p:sp>
          <p:sp>
            <p:nvSpPr>
              <p:cNvPr id="284" name="Rectangle 384">
                <a:extLst>
                  <a:ext uri="{FF2B5EF4-FFF2-40B4-BE49-F238E27FC236}">
                    <a16:creationId xmlns:a16="http://schemas.microsoft.com/office/drawing/2014/main" id="{0090042B-9A85-69AB-65BA-222786FFAE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83966" y="1278052"/>
                <a:ext cx="213058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600</a:t>
                </a:r>
              </a:p>
            </p:txBody>
          </p:sp>
          <p:sp>
            <p:nvSpPr>
              <p:cNvPr id="285" name="Rectangle 385">
                <a:extLst>
                  <a:ext uri="{FF2B5EF4-FFF2-40B4-BE49-F238E27FC236}">
                    <a16:creationId xmlns:a16="http://schemas.microsoft.com/office/drawing/2014/main" id="{52756EF4-00E2-3379-53E6-40247ECF07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6644" y="2563927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0 h</a:t>
                </a:r>
              </a:p>
            </p:txBody>
          </p:sp>
          <p:sp>
            <p:nvSpPr>
              <p:cNvPr id="286" name="Rectangle 386">
                <a:extLst>
                  <a:ext uri="{FF2B5EF4-FFF2-40B4-BE49-F238E27FC236}">
                    <a16:creationId xmlns:a16="http://schemas.microsoft.com/office/drawing/2014/main" id="{A9FF75B6-3AE3-2987-155E-8984A3432A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5980" y="2563927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1 h</a:t>
                </a:r>
              </a:p>
            </p:txBody>
          </p:sp>
          <p:sp>
            <p:nvSpPr>
              <p:cNvPr id="287" name="Rectangle 387">
                <a:extLst>
                  <a:ext uri="{FF2B5EF4-FFF2-40B4-BE49-F238E27FC236}">
                    <a16:creationId xmlns:a16="http://schemas.microsoft.com/office/drawing/2014/main" id="{BEFF4258-4FA2-0A15-96FD-F30C4E0E23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6980" y="2563927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 h</a:t>
                </a:r>
              </a:p>
            </p:txBody>
          </p:sp>
          <p:sp>
            <p:nvSpPr>
              <p:cNvPr id="288" name="Rectangle 388">
                <a:extLst>
                  <a:ext uri="{FF2B5EF4-FFF2-40B4-BE49-F238E27FC236}">
                    <a16:creationId xmlns:a16="http://schemas.microsoft.com/office/drawing/2014/main" id="{8921B590-70E4-AA6A-222C-BACD9AC361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63002" y="2563927"/>
                <a:ext cx="22489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 4 h</a:t>
                </a:r>
              </a:p>
            </p:txBody>
          </p:sp>
          <p:sp>
            <p:nvSpPr>
              <p:cNvPr id="289" name="Rectangle 389">
                <a:extLst>
                  <a:ext uri="{FF2B5EF4-FFF2-40B4-BE49-F238E27FC236}">
                    <a16:creationId xmlns:a16="http://schemas.microsoft.com/office/drawing/2014/main" id="{A1D0127C-C5D1-3B6D-E2EE-E458D1D007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25651" y="2563927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6 h</a:t>
                </a:r>
              </a:p>
            </p:txBody>
          </p:sp>
          <p:sp>
            <p:nvSpPr>
              <p:cNvPr id="290" name="Rectangle 391">
                <a:extLst>
                  <a:ext uri="{FF2B5EF4-FFF2-40B4-BE49-F238E27FC236}">
                    <a16:creationId xmlns:a16="http://schemas.microsoft.com/office/drawing/2014/main" id="{FFAA3593-2E7F-9E73-6078-B48E3063B9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04333" y="2880000"/>
                <a:ext cx="535606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Time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 (h)</a:t>
                </a:r>
              </a:p>
            </p:txBody>
          </p:sp>
          <p:sp>
            <p:nvSpPr>
              <p:cNvPr id="291" name="Rectangle 51">
                <a:extLst>
                  <a:ext uri="{FF2B5EF4-FFF2-40B4-BE49-F238E27FC236}">
                    <a16:creationId xmlns:a16="http://schemas.microsoft.com/office/drawing/2014/main" id="{765D0F6B-176E-B112-79AA-5F571E0BF5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5886556" y="2084900"/>
                <a:ext cx="7792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1" i="0" u="none" strike="noStrike" cap="none" normalizeH="0" baseline="0" dirty="0">
                    <a:ln>
                      <a:noFill/>
                    </a:ln>
                    <a:solidFill>
                      <a:schemeClr val="accent1"/>
                    </a:solidFill>
                    <a:effectLst/>
                    <a:latin typeface="Palatino Linotype" panose="02040502050505030304" pitchFamily="18" charset="0"/>
                  </a:rPr>
                  <a:t>a</a:t>
                </a:r>
              </a:p>
            </p:txBody>
          </p:sp>
          <p:sp>
            <p:nvSpPr>
              <p:cNvPr id="292" name="Rectangle 51">
                <a:extLst>
                  <a:ext uri="{FF2B5EF4-FFF2-40B4-BE49-F238E27FC236}">
                    <a16:creationId xmlns:a16="http://schemas.microsoft.com/office/drawing/2014/main" id="{48FC953B-66AA-1D75-CFDA-BFF109F748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6304564" y="2084900"/>
                <a:ext cx="7792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1" i="0" u="none" strike="noStrike" cap="none" normalizeH="0" baseline="0" dirty="0">
                    <a:ln>
                      <a:noFill/>
                    </a:ln>
                    <a:solidFill>
                      <a:schemeClr val="accent1"/>
                    </a:solidFill>
                    <a:effectLst/>
                    <a:latin typeface="Palatino Linotype" panose="02040502050505030304" pitchFamily="18" charset="0"/>
                  </a:rPr>
                  <a:t>a</a:t>
                </a:r>
              </a:p>
            </p:txBody>
          </p:sp>
          <p:sp>
            <p:nvSpPr>
              <p:cNvPr id="293" name="Rectangle 51">
                <a:extLst>
                  <a:ext uri="{FF2B5EF4-FFF2-40B4-BE49-F238E27FC236}">
                    <a16:creationId xmlns:a16="http://schemas.microsoft.com/office/drawing/2014/main" id="{AE7C32CD-E821-1143-FB31-46C7BD579A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6750279" y="2142247"/>
                <a:ext cx="7792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1" i="0" u="none" strike="noStrike" cap="none" normalizeH="0" baseline="0" dirty="0">
                    <a:ln>
                      <a:noFill/>
                    </a:ln>
                    <a:solidFill>
                      <a:schemeClr val="accent1"/>
                    </a:solidFill>
                    <a:effectLst/>
                    <a:latin typeface="Palatino Linotype" panose="02040502050505030304" pitchFamily="18" charset="0"/>
                  </a:rPr>
                  <a:t>a</a:t>
                </a:r>
              </a:p>
            </p:txBody>
          </p:sp>
          <p:sp>
            <p:nvSpPr>
              <p:cNvPr id="294" name="Rectangle 51">
                <a:extLst>
                  <a:ext uri="{FF2B5EF4-FFF2-40B4-BE49-F238E27FC236}">
                    <a16:creationId xmlns:a16="http://schemas.microsoft.com/office/drawing/2014/main" id="{511B942D-9AAF-0314-0104-670ABD986F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7203920" y="1836852"/>
                <a:ext cx="7792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1" i="0" u="none" strike="noStrike" cap="none" normalizeH="0" baseline="0" dirty="0">
                    <a:ln>
                      <a:noFill/>
                    </a:ln>
                    <a:solidFill>
                      <a:schemeClr val="accent1"/>
                    </a:solidFill>
                    <a:effectLst/>
                    <a:latin typeface="Palatino Linotype" panose="02040502050505030304" pitchFamily="18" charset="0"/>
                  </a:rPr>
                  <a:t>a</a:t>
                </a:r>
              </a:p>
            </p:txBody>
          </p:sp>
          <p:sp>
            <p:nvSpPr>
              <p:cNvPr id="295" name="Rectangle 51">
                <a:extLst>
                  <a:ext uri="{FF2B5EF4-FFF2-40B4-BE49-F238E27FC236}">
                    <a16:creationId xmlns:a16="http://schemas.microsoft.com/office/drawing/2014/main" id="{6D8F8A1F-953D-7CC6-D9F4-DB17DA1D9B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flipH="1">
                <a:off x="7664091" y="1369543"/>
                <a:ext cx="7792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1" i="0" u="none" strike="noStrike" cap="none" normalizeH="0" baseline="0" dirty="0">
                    <a:ln>
                      <a:noFill/>
                    </a:ln>
                    <a:solidFill>
                      <a:schemeClr val="accent1"/>
                    </a:solidFill>
                    <a:effectLst/>
                    <a:latin typeface="Palatino Linotype" panose="02040502050505030304" pitchFamily="18" charset="0"/>
                  </a:rPr>
                  <a:t>b</a:t>
                </a:r>
              </a:p>
            </p:txBody>
          </p:sp>
          <p:cxnSp>
            <p:nvCxnSpPr>
              <p:cNvPr id="301" name="168 Conector recto">
                <a:extLst>
                  <a:ext uri="{FF2B5EF4-FFF2-40B4-BE49-F238E27FC236}">
                    <a16:creationId xmlns:a16="http://schemas.microsoft.com/office/drawing/2014/main" id="{6FFD031B-9718-024B-93CA-73069FD4532E}"/>
                  </a:ext>
                </a:extLst>
              </p:cNvPr>
              <p:cNvCxnSpPr/>
              <p:nvPr/>
            </p:nvCxnSpPr>
            <p:spPr>
              <a:xfrm>
                <a:off x="5736103" y="1202448"/>
                <a:ext cx="0" cy="134557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2" name="170 Conector recto">
                <a:extLst>
                  <a:ext uri="{FF2B5EF4-FFF2-40B4-BE49-F238E27FC236}">
                    <a16:creationId xmlns:a16="http://schemas.microsoft.com/office/drawing/2014/main" id="{019CC2E7-35AF-A790-49D3-0BCBB2450008}"/>
                  </a:ext>
                </a:extLst>
              </p:cNvPr>
              <p:cNvCxnSpPr/>
              <p:nvPr/>
            </p:nvCxnSpPr>
            <p:spPr>
              <a:xfrm flipH="1">
                <a:off x="5646776" y="2491695"/>
                <a:ext cx="235580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ectangle 213">
                <a:extLst>
                  <a:ext uri="{FF2B5EF4-FFF2-40B4-BE49-F238E27FC236}">
                    <a16:creationId xmlns:a16="http://schemas.microsoft.com/office/drawing/2014/main" id="{34002B89-076B-C7B6-2294-5F37950D80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531127" y="1695591"/>
                <a:ext cx="1237735" cy="1704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ca-ES" altLang="ca-ES" sz="1200" dirty="0" err="1">
                    <a:latin typeface="Palatino Linotype" panose="02040502050505030304" pitchFamily="18" charset="0"/>
                  </a:rPr>
                  <a:t>Concentration</a:t>
                </a:r>
                <a:r>
                  <a:rPr lang="ca-ES" altLang="ca-ES" sz="1200" dirty="0">
                    <a:latin typeface="Palatino Linotype" panose="02040502050505030304" pitchFamily="18" charset="0"/>
                  </a:rPr>
                  <a:t> 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(</a:t>
                </a:r>
                <a:r>
                  <a:rPr kumimoji="0" lang="ca-ES" altLang="ca-ES" sz="1200" b="0" i="0" u="none" strike="noStrike" cap="none" normalizeH="0" baseline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nM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)</a:t>
                </a:r>
              </a:p>
            </p:txBody>
          </p:sp>
          <p:sp>
            <p:nvSpPr>
              <p:cNvPr id="26" name="Rectangle 46">
                <a:extLst>
                  <a:ext uri="{FF2B5EF4-FFF2-40B4-BE49-F238E27FC236}">
                    <a16:creationId xmlns:a16="http://schemas.microsoft.com/office/drawing/2014/main" id="{0B039DFD-D2EC-89AC-C0B6-35C0DE6AF5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8064" y="548680"/>
                <a:ext cx="3349362" cy="339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269875" indent="-269875">
                  <a:buFont typeface="+mj-lt"/>
                  <a:buAutoNum type="alphaLcParenR" startAt="2"/>
                </a:pPr>
                <a:r>
                  <a:rPr kumimoji="0" lang="ca-ES" altLang="ca-ES" sz="1200" b="1" i="0" u="none" strike="noStrike" cap="none" normalizeH="0" dirty="0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3-(4’-hydroxy-3’-methoxyphenyl)propanoic </a:t>
                </a:r>
                <a:r>
                  <a:rPr kumimoji="0" lang="ca-ES" altLang="ca-ES" sz="1200" b="1" i="0" u="none" strike="noStrike" cap="none" normalizeH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acid</a:t>
                </a:r>
                <a:r>
                  <a:rPr lang="ca-ES" altLang="ca-ES" sz="1200" b="1" dirty="0">
                    <a:latin typeface="Palatino Linotype" panose="02040502050505030304" pitchFamily="18" charset="0"/>
                    <a:ea typeface="Calibri"/>
                    <a:cs typeface="Arial"/>
                  </a:rPr>
                  <a:t>, N=11 (100%)</a:t>
                </a:r>
                <a:endParaRPr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9" name="Agrupa 28">
              <a:extLst>
                <a:ext uri="{FF2B5EF4-FFF2-40B4-BE49-F238E27FC236}">
                  <a16:creationId xmlns:a16="http://schemas.microsoft.com/office/drawing/2014/main" id="{5A9D56EC-04A5-629A-A0D8-B4F80F8C649B}"/>
                </a:ext>
              </a:extLst>
            </p:cNvPr>
            <p:cNvGrpSpPr/>
            <p:nvPr/>
          </p:nvGrpSpPr>
          <p:grpSpPr>
            <a:xfrm>
              <a:off x="754204" y="3573016"/>
              <a:ext cx="3269506" cy="2419135"/>
              <a:chOff x="4830884" y="3275692"/>
              <a:chExt cx="3269506" cy="2419135"/>
            </a:xfrm>
          </p:grpSpPr>
          <p:sp>
            <p:nvSpPr>
              <p:cNvPr id="310" name="Rectangle 407">
                <a:extLst>
                  <a:ext uri="{FF2B5EF4-FFF2-40B4-BE49-F238E27FC236}">
                    <a16:creationId xmlns:a16="http://schemas.microsoft.com/office/drawing/2014/main" id="{DF3BF176-BDA4-488C-06C4-1427C1926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8865" y="5196621"/>
                <a:ext cx="2203450" cy="7937"/>
              </a:xfrm>
              <a:prstGeom prst="rect">
                <a:avLst/>
              </a:prstGeom>
              <a:solidFill>
                <a:srgbClr val="D9D9D9"/>
              </a:solidFill>
              <a:ln w="1588" cap="flat">
                <a:solidFill>
                  <a:srgbClr val="D9D9D9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1" name="Freeform 408">
                <a:extLst>
                  <a:ext uri="{FF2B5EF4-FFF2-40B4-BE49-F238E27FC236}">
                    <a16:creationId xmlns:a16="http://schemas.microsoft.com/office/drawing/2014/main" id="{9C384862-188E-B47C-8641-279B4200F07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550952" y="4660046"/>
                <a:ext cx="58738" cy="155575"/>
              </a:xfrm>
              <a:custGeom>
                <a:avLst/>
                <a:gdLst>
                  <a:gd name="T0" fmla="*/ 17 w 37"/>
                  <a:gd name="T1" fmla="*/ 98 h 98"/>
                  <a:gd name="T2" fmla="*/ 17 w 37"/>
                  <a:gd name="T3" fmla="*/ 2 h 98"/>
                  <a:gd name="T4" fmla="*/ 20 w 37"/>
                  <a:gd name="T5" fmla="*/ 2 h 98"/>
                  <a:gd name="T6" fmla="*/ 20 w 37"/>
                  <a:gd name="T7" fmla="*/ 98 h 98"/>
                  <a:gd name="T8" fmla="*/ 17 w 37"/>
                  <a:gd name="T9" fmla="*/ 98 h 98"/>
                  <a:gd name="T10" fmla="*/ 0 w 37"/>
                  <a:gd name="T11" fmla="*/ 0 h 98"/>
                  <a:gd name="T12" fmla="*/ 37 w 37"/>
                  <a:gd name="T13" fmla="*/ 0 h 98"/>
                  <a:gd name="T14" fmla="*/ 37 w 37"/>
                  <a:gd name="T15" fmla="*/ 3 h 98"/>
                  <a:gd name="T16" fmla="*/ 0 w 37"/>
                  <a:gd name="T17" fmla="*/ 3 h 98"/>
                  <a:gd name="T18" fmla="*/ 0 w 37"/>
                  <a:gd name="T19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98">
                    <a:moveTo>
                      <a:pt x="17" y="98"/>
                    </a:moveTo>
                    <a:lnTo>
                      <a:pt x="17" y="2"/>
                    </a:lnTo>
                    <a:lnTo>
                      <a:pt x="20" y="2"/>
                    </a:lnTo>
                    <a:lnTo>
                      <a:pt x="20" y="98"/>
                    </a:lnTo>
                    <a:lnTo>
                      <a:pt x="17" y="98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2" name="Freeform 409">
                <a:extLst>
                  <a:ext uri="{FF2B5EF4-FFF2-40B4-BE49-F238E27FC236}">
                    <a16:creationId xmlns:a16="http://schemas.microsoft.com/office/drawing/2014/main" id="{6CEB989A-DC5F-C0C5-66B3-6ED8561910B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992277" y="4748946"/>
                <a:ext cx="57150" cy="104775"/>
              </a:xfrm>
              <a:custGeom>
                <a:avLst/>
                <a:gdLst>
                  <a:gd name="T0" fmla="*/ 16 w 36"/>
                  <a:gd name="T1" fmla="*/ 66 h 66"/>
                  <a:gd name="T2" fmla="*/ 16 w 36"/>
                  <a:gd name="T3" fmla="*/ 2 h 66"/>
                  <a:gd name="T4" fmla="*/ 20 w 36"/>
                  <a:gd name="T5" fmla="*/ 2 h 66"/>
                  <a:gd name="T6" fmla="*/ 20 w 36"/>
                  <a:gd name="T7" fmla="*/ 66 h 66"/>
                  <a:gd name="T8" fmla="*/ 16 w 36"/>
                  <a:gd name="T9" fmla="*/ 66 h 66"/>
                  <a:gd name="T10" fmla="*/ 0 w 36"/>
                  <a:gd name="T11" fmla="*/ 0 h 66"/>
                  <a:gd name="T12" fmla="*/ 36 w 36"/>
                  <a:gd name="T13" fmla="*/ 0 h 66"/>
                  <a:gd name="T14" fmla="*/ 36 w 36"/>
                  <a:gd name="T15" fmla="*/ 4 h 66"/>
                  <a:gd name="T16" fmla="*/ 0 w 36"/>
                  <a:gd name="T17" fmla="*/ 4 h 66"/>
                  <a:gd name="T18" fmla="*/ 0 w 36"/>
                  <a:gd name="T19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66">
                    <a:moveTo>
                      <a:pt x="16" y="66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66"/>
                    </a:lnTo>
                    <a:lnTo>
                      <a:pt x="16" y="6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3" name="Freeform 410">
                <a:extLst>
                  <a:ext uri="{FF2B5EF4-FFF2-40B4-BE49-F238E27FC236}">
                    <a16:creationId xmlns:a16="http://schemas.microsoft.com/office/drawing/2014/main" id="{16445E68-B2AB-30FA-2EBD-F71F227ED90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433602" y="4869596"/>
                <a:ext cx="57150" cy="66675"/>
              </a:xfrm>
              <a:custGeom>
                <a:avLst/>
                <a:gdLst>
                  <a:gd name="T0" fmla="*/ 16 w 36"/>
                  <a:gd name="T1" fmla="*/ 42 h 42"/>
                  <a:gd name="T2" fmla="*/ 16 w 36"/>
                  <a:gd name="T3" fmla="*/ 2 h 42"/>
                  <a:gd name="T4" fmla="*/ 19 w 36"/>
                  <a:gd name="T5" fmla="*/ 2 h 42"/>
                  <a:gd name="T6" fmla="*/ 19 w 36"/>
                  <a:gd name="T7" fmla="*/ 42 h 42"/>
                  <a:gd name="T8" fmla="*/ 16 w 36"/>
                  <a:gd name="T9" fmla="*/ 42 h 42"/>
                  <a:gd name="T10" fmla="*/ 0 w 36"/>
                  <a:gd name="T11" fmla="*/ 0 h 42"/>
                  <a:gd name="T12" fmla="*/ 36 w 36"/>
                  <a:gd name="T13" fmla="*/ 0 h 42"/>
                  <a:gd name="T14" fmla="*/ 36 w 36"/>
                  <a:gd name="T15" fmla="*/ 4 h 42"/>
                  <a:gd name="T16" fmla="*/ 0 w 36"/>
                  <a:gd name="T17" fmla="*/ 4 h 42"/>
                  <a:gd name="T18" fmla="*/ 0 w 36"/>
                  <a:gd name="T19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42">
                    <a:moveTo>
                      <a:pt x="16" y="42"/>
                    </a:moveTo>
                    <a:lnTo>
                      <a:pt x="16" y="2"/>
                    </a:lnTo>
                    <a:lnTo>
                      <a:pt x="19" y="2"/>
                    </a:lnTo>
                    <a:lnTo>
                      <a:pt x="19" y="42"/>
                    </a:lnTo>
                    <a:lnTo>
                      <a:pt x="16" y="4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4" name="Freeform 411">
                <a:extLst>
                  <a:ext uri="{FF2B5EF4-FFF2-40B4-BE49-F238E27FC236}">
                    <a16:creationId xmlns:a16="http://schemas.microsoft.com/office/drawing/2014/main" id="{53A85B76-CAA6-C81D-BAF1-ACB7E9EE1091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874927" y="4864834"/>
                <a:ext cx="55563" cy="55562"/>
              </a:xfrm>
              <a:custGeom>
                <a:avLst/>
                <a:gdLst>
                  <a:gd name="T0" fmla="*/ 16 w 35"/>
                  <a:gd name="T1" fmla="*/ 35 h 35"/>
                  <a:gd name="T2" fmla="*/ 16 w 35"/>
                  <a:gd name="T3" fmla="*/ 2 h 35"/>
                  <a:gd name="T4" fmla="*/ 20 w 35"/>
                  <a:gd name="T5" fmla="*/ 2 h 35"/>
                  <a:gd name="T6" fmla="*/ 20 w 35"/>
                  <a:gd name="T7" fmla="*/ 35 h 35"/>
                  <a:gd name="T8" fmla="*/ 16 w 35"/>
                  <a:gd name="T9" fmla="*/ 35 h 35"/>
                  <a:gd name="T10" fmla="*/ 0 w 35"/>
                  <a:gd name="T11" fmla="*/ 0 h 35"/>
                  <a:gd name="T12" fmla="*/ 35 w 35"/>
                  <a:gd name="T13" fmla="*/ 0 h 35"/>
                  <a:gd name="T14" fmla="*/ 35 w 35"/>
                  <a:gd name="T15" fmla="*/ 4 h 35"/>
                  <a:gd name="T16" fmla="*/ 0 w 35"/>
                  <a:gd name="T17" fmla="*/ 4 h 35"/>
                  <a:gd name="T18" fmla="*/ 0 w 35"/>
                  <a:gd name="T1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35">
                    <a:moveTo>
                      <a:pt x="16" y="35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35"/>
                    </a:lnTo>
                    <a:lnTo>
                      <a:pt x="16" y="35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5" name="Freeform 412">
                <a:extLst>
                  <a:ext uri="{FF2B5EF4-FFF2-40B4-BE49-F238E27FC236}">
                    <a16:creationId xmlns:a16="http://schemas.microsoft.com/office/drawing/2014/main" id="{59809619-8EF1-412D-FE0A-B0BCD6CA58A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314665" y="4629884"/>
                <a:ext cx="57150" cy="85725"/>
              </a:xfrm>
              <a:custGeom>
                <a:avLst/>
                <a:gdLst>
                  <a:gd name="T0" fmla="*/ 16 w 36"/>
                  <a:gd name="T1" fmla="*/ 54 h 54"/>
                  <a:gd name="T2" fmla="*/ 16 w 36"/>
                  <a:gd name="T3" fmla="*/ 2 h 54"/>
                  <a:gd name="T4" fmla="*/ 20 w 36"/>
                  <a:gd name="T5" fmla="*/ 2 h 54"/>
                  <a:gd name="T6" fmla="*/ 20 w 36"/>
                  <a:gd name="T7" fmla="*/ 54 h 54"/>
                  <a:gd name="T8" fmla="*/ 16 w 36"/>
                  <a:gd name="T9" fmla="*/ 54 h 54"/>
                  <a:gd name="T10" fmla="*/ 0 w 36"/>
                  <a:gd name="T11" fmla="*/ 0 h 54"/>
                  <a:gd name="T12" fmla="*/ 36 w 36"/>
                  <a:gd name="T13" fmla="*/ 0 h 54"/>
                  <a:gd name="T14" fmla="*/ 36 w 36"/>
                  <a:gd name="T15" fmla="*/ 4 h 54"/>
                  <a:gd name="T16" fmla="*/ 0 w 36"/>
                  <a:gd name="T17" fmla="*/ 4 h 54"/>
                  <a:gd name="T18" fmla="*/ 0 w 36"/>
                  <a:gd name="T19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54">
                    <a:moveTo>
                      <a:pt x="16" y="54"/>
                    </a:moveTo>
                    <a:lnTo>
                      <a:pt x="16" y="2"/>
                    </a:lnTo>
                    <a:lnTo>
                      <a:pt x="20" y="2"/>
                    </a:lnTo>
                    <a:lnTo>
                      <a:pt x="20" y="54"/>
                    </a:lnTo>
                    <a:lnTo>
                      <a:pt x="16" y="5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1" name="Freeform 418">
                <a:extLst>
                  <a:ext uri="{FF2B5EF4-FFF2-40B4-BE49-F238E27FC236}">
                    <a16:creationId xmlns:a16="http://schemas.microsoft.com/office/drawing/2014/main" id="{723F300B-6DF4-5477-4101-06645410080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66827" y="4699734"/>
                <a:ext cx="1792288" cy="250825"/>
              </a:xfrm>
              <a:custGeom>
                <a:avLst/>
                <a:gdLst>
                  <a:gd name="T0" fmla="*/ 163 w 18827"/>
                  <a:gd name="T1" fmla="*/ 1061 h 2629"/>
                  <a:gd name="T2" fmla="*/ 4787 w 18827"/>
                  <a:gd name="T3" fmla="*/ 1461 h 2629"/>
                  <a:gd name="T4" fmla="*/ 9425 w 18827"/>
                  <a:gd name="T5" fmla="*/ 2343 h 2629"/>
                  <a:gd name="T6" fmla="*/ 9393 w 18827"/>
                  <a:gd name="T7" fmla="*/ 2341 h 2629"/>
                  <a:gd name="T8" fmla="*/ 14033 w 18827"/>
                  <a:gd name="T9" fmla="*/ 2165 h 2629"/>
                  <a:gd name="T10" fmla="*/ 13978 w 18827"/>
                  <a:gd name="T11" fmla="*/ 2178 h 2629"/>
                  <a:gd name="T12" fmla="*/ 18602 w 18827"/>
                  <a:gd name="T13" fmla="*/ 34 h 2629"/>
                  <a:gd name="T14" fmla="*/ 18793 w 18827"/>
                  <a:gd name="T15" fmla="*/ 104 h 2629"/>
                  <a:gd name="T16" fmla="*/ 18723 w 18827"/>
                  <a:gd name="T17" fmla="*/ 295 h 2629"/>
                  <a:gd name="T18" fmla="*/ 14099 w 18827"/>
                  <a:gd name="T19" fmla="*/ 2439 h 2629"/>
                  <a:gd name="T20" fmla="*/ 14044 w 18827"/>
                  <a:gd name="T21" fmla="*/ 2452 h 2629"/>
                  <a:gd name="T22" fmla="*/ 9404 w 18827"/>
                  <a:gd name="T23" fmla="*/ 2628 h 2629"/>
                  <a:gd name="T24" fmla="*/ 9372 w 18827"/>
                  <a:gd name="T25" fmla="*/ 2626 h 2629"/>
                  <a:gd name="T26" fmla="*/ 4762 w 18827"/>
                  <a:gd name="T27" fmla="*/ 1748 h 2629"/>
                  <a:gd name="T28" fmla="*/ 138 w 18827"/>
                  <a:gd name="T29" fmla="*/ 1348 h 2629"/>
                  <a:gd name="T30" fmla="*/ 7 w 18827"/>
                  <a:gd name="T31" fmla="*/ 1192 h 2629"/>
                  <a:gd name="T32" fmla="*/ 163 w 18827"/>
                  <a:gd name="T33" fmla="*/ 1061 h 26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8827" h="2629">
                    <a:moveTo>
                      <a:pt x="163" y="1061"/>
                    </a:moveTo>
                    <a:lnTo>
                      <a:pt x="4787" y="1461"/>
                    </a:lnTo>
                    <a:lnTo>
                      <a:pt x="9425" y="2343"/>
                    </a:lnTo>
                    <a:lnTo>
                      <a:pt x="9393" y="2341"/>
                    </a:lnTo>
                    <a:lnTo>
                      <a:pt x="14033" y="2165"/>
                    </a:lnTo>
                    <a:lnTo>
                      <a:pt x="13978" y="2178"/>
                    </a:lnTo>
                    <a:lnTo>
                      <a:pt x="18602" y="34"/>
                    </a:lnTo>
                    <a:cubicBezTo>
                      <a:pt x="18674" y="0"/>
                      <a:pt x="18760" y="32"/>
                      <a:pt x="18793" y="104"/>
                    </a:cubicBezTo>
                    <a:cubicBezTo>
                      <a:pt x="18827" y="176"/>
                      <a:pt x="18795" y="262"/>
                      <a:pt x="18723" y="295"/>
                    </a:cubicBezTo>
                    <a:lnTo>
                      <a:pt x="14099" y="2439"/>
                    </a:lnTo>
                    <a:cubicBezTo>
                      <a:pt x="14082" y="2447"/>
                      <a:pt x="14063" y="2452"/>
                      <a:pt x="14044" y="2452"/>
                    </a:cubicBezTo>
                    <a:lnTo>
                      <a:pt x="9404" y="2628"/>
                    </a:lnTo>
                    <a:cubicBezTo>
                      <a:pt x="9393" y="2629"/>
                      <a:pt x="9382" y="2628"/>
                      <a:pt x="9372" y="2626"/>
                    </a:cubicBezTo>
                    <a:lnTo>
                      <a:pt x="4762" y="1748"/>
                    </a:lnTo>
                    <a:lnTo>
                      <a:pt x="138" y="1348"/>
                    </a:lnTo>
                    <a:cubicBezTo>
                      <a:pt x="59" y="1341"/>
                      <a:pt x="0" y="1271"/>
                      <a:pt x="7" y="1192"/>
                    </a:cubicBezTo>
                    <a:cubicBezTo>
                      <a:pt x="14" y="1113"/>
                      <a:pt x="84" y="1054"/>
                      <a:pt x="163" y="1061"/>
                    </a:cubicBezTo>
                    <a:close/>
                  </a:path>
                </a:pathLst>
              </a:custGeom>
              <a:solidFill>
                <a:srgbClr val="5B9BD5"/>
              </a:solidFill>
              <a:ln w="1588" cap="flat">
                <a:solidFill>
                  <a:srgbClr val="5B9BD5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2" name="Oval 419">
                <a:extLst>
                  <a:ext uri="{FF2B5EF4-FFF2-40B4-BE49-F238E27FC236}">
                    <a16:creationId xmlns:a16="http://schemas.microsoft.com/office/drawing/2014/main" id="{22F698BF-13F0-880A-8F27-476FCDA969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47777" y="4780696"/>
                <a:ext cx="65088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3" name="Oval 420">
                <a:extLst>
                  <a:ext uri="{FF2B5EF4-FFF2-40B4-BE49-F238E27FC236}">
                    <a16:creationId xmlns:a16="http://schemas.microsoft.com/office/drawing/2014/main" id="{CE2B4DC8-2A29-5641-380F-B054D2C3F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47777" y="4780696"/>
                <a:ext cx="65088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4" name="Oval 421">
                <a:extLst>
                  <a:ext uri="{FF2B5EF4-FFF2-40B4-BE49-F238E27FC236}">
                    <a16:creationId xmlns:a16="http://schemas.microsoft.com/office/drawing/2014/main" id="{37A2218F-EA49-F4F9-AA8C-29D59AF8BB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9102" y="4818796"/>
                <a:ext cx="63500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5" name="Oval 422">
                <a:extLst>
                  <a:ext uri="{FF2B5EF4-FFF2-40B4-BE49-F238E27FC236}">
                    <a16:creationId xmlns:a16="http://schemas.microsoft.com/office/drawing/2014/main" id="{701E34BE-E5FD-8C40-0368-9DF84326D9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89102" y="4818796"/>
                <a:ext cx="63500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6" name="Oval 423">
                <a:extLst>
                  <a:ext uri="{FF2B5EF4-FFF2-40B4-BE49-F238E27FC236}">
                    <a16:creationId xmlns:a16="http://schemas.microsoft.com/office/drawing/2014/main" id="{FBEDAB8E-253D-6D15-D8ED-68BDED3FED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28840" y="4902934"/>
                <a:ext cx="65088" cy="65087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7" name="Oval 424">
                <a:extLst>
                  <a:ext uri="{FF2B5EF4-FFF2-40B4-BE49-F238E27FC236}">
                    <a16:creationId xmlns:a16="http://schemas.microsoft.com/office/drawing/2014/main" id="{1DEE7C66-8378-354B-E902-5027AC91D2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28840" y="4902934"/>
                <a:ext cx="65088" cy="65087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8" name="Oval 425">
                <a:extLst>
                  <a:ext uri="{FF2B5EF4-FFF2-40B4-BE49-F238E27FC236}">
                    <a16:creationId xmlns:a16="http://schemas.microsoft.com/office/drawing/2014/main" id="{839C898A-F395-46CA-D85C-EC06A93900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70165" y="4887059"/>
                <a:ext cx="63500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9" name="Oval 426">
                <a:extLst>
                  <a:ext uri="{FF2B5EF4-FFF2-40B4-BE49-F238E27FC236}">
                    <a16:creationId xmlns:a16="http://schemas.microsoft.com/office/drawing/2014/main" id="{B296377D-7A85-988A-A34D-5449EB8D5D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70165" y="4887059"/>
                <a:ext cx="63500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0" name="Oval 427">
                <a:extLst>
                  <a:ext uri="{FF2B5EF4-FFF2-40B4-BE49-F238E27FC236}">
                    <a16:creationId xmlns:a16="http://schemas.microsoft.com/office/drawing/2014/main" id="{36A16C1B-7F36-4E1A-18E8-E3DFB65C08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9902" y="4683859"/>
                <a:ext cx="63500" cy="63500"/>
              </a:xfrm>
              <a:prstGeom prst="ellipse">
                <a:avLst/>
              </a:prstGeom>
              <a:solidFill>
                <a:srgbClr val="5B9BD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1" name="Oval 428">
                <a:extLst>
                  <a:ext uri="{FF2B5EF4-FFF2-40B4-BE49-F238E27FC236}">
                    <a16:creationId xmlns:a16="http://schemas.microsoft.com/office/drawing/2014/main" id="{40A0FD1E-7254-C18B-1158-D2ADFC05A4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09902" y="4683859"/>
                <a:ext cx="63500" cy="63500"/>
              </a:xfrm>
              <a:prstGeom prst="ellipse">
                <a:avLst/>
              </a:prstGeom>
              <a:noFill/>
              <a:ln w="9525" cap="flat">
                <a:solidFill>
                  <a:srgbClr val="5B9BD5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ca-E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3" name="Rectangle 440">
                <a:extLst>
                  <a:ext uri="{FF2B5EF4-FFF2-40B4-BE49-F238E27FC236}">
                    <a16:creationId xmlns:a16="http://schemas.microsoft.com/office/drawing/2014/main" id="{90CFE6A3-6704-9655-78D1-ACE2C4179E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96940" y="5123596"/>
                <a:ext cx="7101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0</a:t>
                </a:r>
              </a:p>
            </p:txBody>
          </p:sp>
          <p:sp>
            <p:nvSpPr>
              <p:cNvPr id="344" name="Rectangle 441">
                <a:extLst>
                  <a:ext uri="{FF2B5EF4-FFF2-40B4-BE49-F238E27FC236}">
                    <a16:creationId xmlns:a16="http://schemas.microsoft.com/office/drawing/2014/main" id="{E19A45F1-ACCD-30DA-B3BA-CE2EAFE36B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963259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10</a:t>
                </a:r>
              </a:p>
            </p:txBody>
          </p:sp>
          <p:sp>
            <p:nvSpPr>
              <p:cNvPr id="345" name="Rectangle 442">
                <a:extLst>
                  <a:ext uri="{FF2B5EF4-FFF2-40B4-BE49-F238E27FC236}">
                    <a16:creationId xmlns:a16="http://schemas.microsoft.com/office/drawing/2014/main" id="{78651F6C-F3F6-D920-CC04-086DB803DA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802921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0</a:t>
                </a:r>
              </a:p>
            </p:txBody>
          </p:sp>
          <p:sp>
            <p:nvSpPr>
              <p:cNvPr id="346" name="Rectangle 443">
                <a:extLst>
                  <a:ext uri="{FF2B5EF4-FFF2-40B4-BE49-F238E27FC236}">
                    <a16:creationId xmlns:a16="http://schemas.microsoft.com/office/drawing/2014/main" id="{8C7254A0-2B37-5AC4-1E9D-D72D4934F9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640996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30</a:t>
                </a:r>
              </a:p>
            </p:txBody>
          </p:sp>
          <p:sp>
            <p:nvSpPr>
              <p:cNvPr id="347" name="Rectangle 444">
                <a:extLst>
                  <a:ext uri="{FF2B5EF4-FFF2-40B4-BE49-F238E27FC236}">
                    <a16:creationId xmlns:a16="http://schemas.microsoft.com/office/drawing/2014/main" id="{C740C51E-A29D-06BD-5E27-6F5964AB19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479071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40</a:t>
                </a:r>
              </a:p>
            </p:txBody>
          </p:sp>
          <p:sp>
            <p:nvSpPr>
              <p:cNvPr id="348" name="Rectangle 445">
                <a:extLst>
                  <a:ext uri="{FF2B5EF4-FFF2-40B4-BE49-F238E27FC236}">
                    <a16:creationId xmlns:a16="http://schemas.microsoft.com/office/drawing/2014/main" id="{82D316C2-4F7F-BB81-A37E-46F6F22DE9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318734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50</a:t>
                </a:r>
              </a:p>
            </p:txBody>
          </p:sp>
          <p:sp>
            <p:nvSpPr>
              <p:cNvPr id="349" name="Rectangle 446">
                <a:extLst>
                  <a:ext uri="{FF2B5EF4-FFF2-40B4-BE49-F238E27FC236}">
                    <a16:creationId xmlns:a16="http://schemas.microsoft.com/office/drawing/2014/main" id="{CD58EF55-8F1D-91D4-5CB9-0BC7626D45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4158396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60</a:t>
                </a:r>
              </a:p>
            </p:txBody>
          </p:sp>
          <p:sp>
            <p:nvSpPr>
              <p:cNvPr id="350" name="Rectangle 447">
                <a:extLst>
                  <a:ext uri="{FF2B5EF4-FFF2-40B4-BE49-F238E27FC236}">
                    <a16:creationId xmlns:a16="http://schemas.microsoft.com/office/drawing/2014/main" id="{E69A94E4-18F6-2F2F-D808-5C73B34AAC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8202" y="3996471"/>
                <a:ext cx="142039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70</a:t>
                </a:r>
              </a:p>
            </p:txBody>
          </p:sp>
          <p:sp>
            <p:nvSpPr>
              <p:cNvPr id="351" name="Rectangle 448">
                <a:extLst>
                  <a:ext uri="{FF2B5EF4-FFF2-40B4-BE49-F238E27FC236}">
                    <a16:creationId xmlns:a16="http://schemas.microsoft.com/office/drawing/2014/main" id="{0308BD35-C9AD-E549-EDCC-C67B4DB150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08090" y="5272821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0 h</a:t>
                </a:r>
              </a:p>
            </p:txBody>
          </p:sp>
          <p:sp>
            <p:nvSpPr>
              <p:cNvPr id="352" name="Rectangle 449">
                <a:extLst>
                  <a:ext uri="{FF2B5EF4-FFF2-40B4-BE49-F238E27FC236}">
                    <a16:creationId xmlns:a16="http://schemas.microsoft.com/office/drawing/2014/main" id="{0CB20B9C-627A-2C99-26DC-DFEA5EF5CE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49415" y="5272821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1 h</a:t>
                </a:r>
              </a:p>
            </p:txBody>
          </p:sp>
          <p:sp>
            <p:nvSpPr>
              <p:cNvPr id="353" name="Rectangle 450">
                <a:extLst>
                  <a:ext uri="{FF2B5EF4-FFF2-40B4-BE49-F238E27FC236}">
                    <a16:creationId xmlns:a16="http://schemas.microsoft.com/office/drawing/2014/main" id="{ED259A3B-4AFA-8C67-C17D-456107DB32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89152" y="5272821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2 h</a:t>
                </a:r>
              </a:p>
            </p:txBody>
          </p:sp>
          <p:sp>
            <p:nvSpPr>
              <p:cNvPr id="354" name="Rectangle 451">
                <a:extLst>
                  <a:ext uri="{FF2B5EF4-FFF2-40B4-BE49-F238E27FC236}">
                    <a16:creationId xmlns:a16="http://schemas.microsoft.com/office/drawing/2014/main" id="{7737BAF3-7634-3679-DF06-CE98BD1AD5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17777" y="5272821"/>
                <a:ext cx="22489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 4 h</a:t>
                </a:r>
              </a:p>
            </p:txBody>
          </p:sp>
          <p:sp>
            <p:nvSpPr>
              <p:cNvPr id="355" name="Rectangle 452">
                <a:extLst>
                  <a:ext uri="{FF2B5EF4-FFF2-40B4-BE49-F238E27FC236}">
                    <a16:creationId xmlns:a16="http://schemas.microsoft.com/office/drawing/2014/main" id="{33E1EECE-D4AC-0475-B3D2-E8CFFAF749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71802" y="5272821"/>
                <a:ext cx="189385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6 h</a:t>
                </a:r>
              </a:p>
            </p:txBody>
          </p:sp>
          <p:sp>
            <p:nvSpPr>
              <p:cNvPr id="356" name="Rectangle 454">
                <a:extLst>
                  <a:ext uri="{FF2B5EF4-FFF2-40B4-BE49-F238E27FC236}">
                    <a16:creationId xmlns:a16="http://schemas.microsoft.com/office/drawing/2014/main" id="{12A63C29-3A59-C179-4CF4-0CA62A7A1F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36680" y="5525080"/>
                <a:ext cx="535606" cy="1697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ca-ES" altLang="ca-ES" sz="1200" b="0" i="0" u="none" strike="noStrike" cap="none" normalizeH="0" baseline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Time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 (h)</a:t>
                </a:r>
              </a:p>
            </p:txBody>
          </p:sp>
          <p:cxnSp>
            <p:nvCxnSpPr>
              <p:cNvPr id="362" name="168 Conector recto">
                <a:extLst>
                  <a:ext uri="{FF2B5EF4-FFF2-40B4-BE49-F238E27FC236}">
                    <a16:creationId xmlns:a16="http://schemas.microsoft.com/office/drawing/2014/main" id="{504DAD36-F314-1395-068D-B76298C8E60D}"/>
                  </a:ext>
                </a:extLst>
              </p:cNvPr>
              <p:cNvCxnSpPr/>
              <p:nvPr/>
            </p:nvCxnSpPr>
            <p:spPr>
              <a:xfrm>
                <a:off x="5405269" y="3924463"/>
                <a:ext cx="0" cy="1324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170 Conector recto">
                <a:extLst>
                  <a:ext uri="{FF2B5EF4-FFF2-40B4-BE49-F238E27FC236}">
                    <a16:creationId xmlns:a16="http://schemas.microsoft.com/office/drawing/2014/main" id="{8DC5FF3D-0EF8-D5E9-A702-92385C476001}"/>
                  </a:ext>
                </a:extLst>
              </p:cNvPr>
              <p:cNvCxnSpPr/>
              <p:nvPr/>
            </p:nvCxnSpPr>
            <p:spPr>
              <a:xfrm flipH="1">
                <a:off x="5320059" y="5192407"/>
                <a:ext cx="22472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Rectangle 213">
                <a:extLst>
                  <a:ext uri="{FF2B5EF4-FFF2-40B4-BE49-F238E27FC236}">
                    <a16:creationId xmlns:a16="http://schemas.microsoft.com/office/drawing/2014/main" id="{18EE3F26-B098-FE1C-0840-5A8EAFA433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297240" y="4361596"/>
                <a:ext cx="1237735" cy="1704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ca-ES" altLang="ca-ES" sz="1200" dirty="0" err="1">
                    <a:latin typeface="Palatino Linotype" panose="02040502050505030304" pitchFamily="18" charset="0"/>
                  </a:rPr>
                  <a:t>Concentration</a:t>
                </a:r>
                <a:r>
                  <a:rPr lang="ca-ES" altLang="ca-ES" sz="1200" dirty="0">
                    <a:latin typeface="Palatino Linotype" panose="02040502050505030304" pitchFamily="18" charset="0"/>
                  </a:rPr>
                  <a:t> 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(</a:t>
                </a:r>
                <a:r>
                  <a:rPr kumimoji="0" lang="ca-ES" altLang="ca-ES" sz="1200" b="0" i="0" u="none" strike="noStrike" cap="none" normalizeH="0" baseline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nM</a:t>
                </a:r>
                <a:r>
                  <a:rPr kumimoji="0" lang="ca-ES" altLang="ca-ES" sz="1200" b="0" i="0" u="none" strike="noStrike" cap="none" normalizeH="0" baseline="0" dirty="0">
                    <a:ln>
                      <a:noFill/>
                    </a:ln>
                    <a:effectLst/>
                    <a:latin typeface="Palatino Linotype" panose="02040502050505030304" pitchFamily="18" charset="0"/>
                  </a:rPr>
                  <a:t>)</a:t>
                </a:r>
              </a:p>
            </p:txBody>
          </p:sp>
          <p:sp>
            <p:nvSpPr>
              <p:cNvPr id="27" name="Rectangle 46">
                <a:extLst>
                  <a:ext uri="{FF2B5EF4-FFF2-40B4-BE49-F238E27FC236}">
                    <a16:creationId xmlns:a16="http://schemas.microsoft.com/office/drawing/2014/main" id="{45A1A68E-CB21-EA14-2D83-8C7AEB04C3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5412" y="3275692"/>
                <a:ext cx="3194978" cy="3394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269875" indent="-269875">
                  <a:buFont typeface="+mj-lt"/>
                  <a:buAutoNum type="alphaLcParenR" startAt="3"/>
                </a:pPr>
                <a:r>
                  <a:rPr kumimoji="0" lang="ca-ES" altLang="ca-ES" sz="1200" b="1" i="0" u="none" strike="noStrike" cap="none" normalizeH="0" dirty="0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3-(4’-hydroxy-3’-methoxyphenyl)propanoic </a:t>
                </a:r>
                <a:r>
                  <a:rPr kumimoji="0" lang="ca-ES" altLang="ca-ES" sz="1200" b="1" i="0" u="none" strike="noStrike" cap="none" normalizeH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acid</a:t>
                </a:r>
                <a:r>
                  <a:rPr kumimoji="0" lang="ca-ES" altLang="ca-ES" sz="1200" b="1" i="0" u="none" strike="noStrike" cap="none" normalizeH="0" dirty="0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-</a:t>
                </a:r>
                <a:r>
                  <a:rPr kumimoji="0" lang="ca-ES" altLang="ca-ES" sz="1200" b="1" i="1" u="none" strike="noStrike" cap="none" normalizeH="0" dirty="0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O</a:t>
                </a:r>
                <a:r>
                  <a:rPr kumimoji="0" lang="ca-ES" altLang="ca-ES" sz="1200" b="1" i="0" u="none" strike="noStrike" cap="none" normalizeH="0" dirty="0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-</a:t>
                </a:r>
                <a:r>
                  <a:rPr kumimoji="0" lang="ca-ES" altLang="ca-ES" sz="1200" b="1" i="0" u="none" strike="noStrike" cap="none" normalizeH="0" dirty="0" err="1">
                    <a:ln>
                      <a:noFill/>
                    </a:ln>
                    <a:effectLst/>
                    <a:latin typeface="Palatino Linotype" panose="02040502050505030304" pitchFamily="18" charset="0"/>
                    <a:ea typeface="Calibri"/>
                    <a:cs typeface="Arial"/>
                  </a:rPr>
                  <a:t>sulphate</a:t>
                </a:r>
                <a:r>
                  <a:rPr lang="ca-ES" altLang="ca-ES" sz="1200" b="1" dirty="0">
                    <a:latin typeface="Palatino Linotype" panose="02040502050505030304" pitchFamily="18" charset="0"/>
                    <a:ea typeface="Calibri"/>
                    <a:cs typeface="Arial"/>
                  </a:rPr>
                  <a:t>, N=9 (81,8%)</a:t>
                </a:r>
                <a:endParaRPr lang="ca-ES" altLang="ca-ES" sz="1200" b="1" i="0" u="none" strike="noStrike" cap="none" normalizeH="0" baseline="0" dirty="0">
                  <a:ln>
                    <a:noFill/>
                  </a:ln>
                  <a:effectLst/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11" name="CuadroTexto 24">
            <a:extLst>
              <a:ext uri="{FF2B5EF4-FFF2-40B4-BE49-F238E27FC236}">
                <a16:creationId xmlns:a16="http://schemas.microsoft.com/office/drawing/2014/main" id="{75C973A3-093C-ABA7-7CF4-45CB865433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6176" y="6237312"/>
            <a:ext cx="270986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r"/>
            <a:r>
              <a:rPr lang="ca-ES" altLang="ca-ES" sz="1400" b="1" dirty="0" err="1">
                <a:latin typeface="Palatino Linotype" panose="02040502050505030304" pitchFamily="18" charset="0"/>
                <a:cs typeface="Calibri" panose="020F0502020204030204" pitchFamily="34" charset="0"/>
              </a:rPr>
              <a:t>Supplementary</a:t>
            </a:r>
            <a:r>
              <a:rPr lang="ca-ES" altLang="ca-ES" sz="14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 </a:t>
            </a:r>
            <a:r>
              <a:rPr lang="ca-ES" altLang="ca-ES" sz="1400" b="1" err="1">
                <a:latin typeface="Palatino Linotype" panose="02040502050505030304" pitchFamily="18" charset="0"/>
                <a:cs typeface="Calibri" panose="020F0502020204030204" pitchFamily="34" charset="0"/>
              </a:rPr>
              <a:t>Figure</a:t>
            </a:r>
            <a:r>
              <a:rPr lang="ca-ES" altLang="ca-ES" sz="1400" b="1">
                <a:latin typeface="Palatino Linotype" panose="02040502050505030304" pitchFamily="18" charset="0"/>
                <a:cs typeface="Calibri" panose="020F0502020204030204" pitchFamily="34" charset="0"/>
              </a:rPr>
              <a:t> S3</a:t>
            </a:r>
            <a:endParaRPr lang="ca-ES" altLang="ca-ES" sz="1400" b="1" dirty="0">
              <a:latin typeface="Palatino Linotype" panose="020405020505050303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9733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1</TotalTime>
  <Words>145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e Office</vt:lpstr>
      <vt:lpstr>PowerPoint Presentation</vt:lpstr>
    </vt:vector>
  </TitlesOfParts>
  <Company>Universitat de Lle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dL</dc:creator>
  <cp:lastModifiedBy>MDPI</cp:lastModifiedBy>
  <cp:revision>59</cp:revision>
  <dcterms:created xsi:type="dcterms:W3CDTF">2024-06-17T07:27:40Z</dcterms:created>
  <dcterms:modified xsi:type="dcterms:W3CDTF">2025-09-28T09:33:52Z</dcterms:modified>
</cp:coreProperties>
</file>